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8"/>
  </p:notesMasterIdLst>
  <p:sldIdLst>
    <p:sldId id="258" r:id="rId2"/>
    <p:sldId id="257" r:id="rId3"/>
    <p:sldId id="260" r:id="rId4"/>
    <p:sldId id="259" r:id="rId5"/>
    <p:sldId id="284" r:id="rId6"/>
    <p:sldId id="313" r:id="rId7"/>
    <p:sldId id="314" r:id="rId8"/>
    <p:sldId id="311" r:id="rId9"/>
    <p:sldId id="315" r:id="rId10"/>
    <p:sldId id="261" r:id="rId11"/>
    <p:sldId id="265" r:id="rId12"/>
    <p:sldId id="267" r:id="rId13"/>
    <p:sldId id="262" r:id="rId14"/>
    <p:sldId id="266" r:id="rId15"/>
    <p:sldId id="263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  <p:sldId id="312" r:id="rId33"/>
    <p:sldId id="285" r:id="rId34"/>
    <p:sldId id="286" r:id="rId35"/>
    <p:sldId id="287" r:id="rId36"/>
    <p:sldId id="288" r:id="rId37"/>
    <p:sldId id="289" r:id="rId38"/>
    <p:sldId id="291" r:id="rId39"/>
    <p:sldId id="290" r:id="rId40"/>
    <p:sldId id="292" r:id="rId41"/>
    <p:sldId id="301" r:id="rId42"/>
    <p:sldId id="302" r:id="rId43"/>
    <p:sldId id="303" r:id="rId44"/>
    <p:sldId id="304" r:id="rId45"/>
    <p:sldId id="305" r:id="rId46"/>
    <p:sldId id="306" r:id="rId47"/>
    <p:sldId id="307" r:id="rId48"/>
    <p:sldId id="308" r:id="rId49"/>
    <p:sldId id="309" r:id="rId50"/>
    <p:sldId id="310" r:id="rId51"/>
    <p:sldId id="298" r:id="rId52"/>
    <p:sldId id="294" r:id="rId53"/>
    <p:sldId id="295" r:id="rId54"/>
    <p:sldId id="300" r:id="rId55"/>
    <p:sldId id="299" r:id="rId56"/>
    <p:sldId id="264" r:id="rId5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1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D4EB75-CC25-4E3C-B301-9556E55C1F76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3963EE-9F72-4B7D-8D7B-F28D18373E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615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9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0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3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01878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1637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4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40515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4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49329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4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579195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4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22902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4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341490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4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906272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5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441632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5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230227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5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4420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693329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5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956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12592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37942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94050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65653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07407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3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86605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3963EE-9F72-4B7D-8D7B-F28D18373E18}" type="slidenum">
              <a:rPr lang="en-US" smtClean="0"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6566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8AC0EB-8019-4677-BB51-9D5007D1A1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A9D92C3-CE07-4809-A9C0-F8316CDDF9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C9636A-56C0-469B-B186-35E534B5C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343DE4-92A1-4C1B-AB3A-5AF70B4EAD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1BAA3C-3ACF-48DC-ABDF-F6B38C6A0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815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E93B53-5641-4C20-BDE9-E6BC8A9116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AB0A49-F32B-40BB-A841-4D91118A08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13D415-ED5E-47FA-9492-D579EF0AF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8958F5-BAD1-46EC-96D9-A39676FA4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1A541D-1812-433E-921A-B507C7B53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339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9EF570-ACA0-421A-8FCE-20401F25F7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AA4D9C-CEBA-4559-8660-C145464AA6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D7F067-AB44-43BB-8319-6BE7B322A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4873DF-3C30-4DFF-B2B3-4351BC845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4587CF-EBA5-43DA-A4C1-C44360AC1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212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65499-A795-4EE1-9459-D666391B20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CD5009-EA18-46DA-BA6A-6237AF995D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6ED185-F7A4-4590-80F7-448EA07F6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0711B9-9C2D-4268-BA61-FFCF7CAAF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11FF0B-3DA4-4A69-9556-08FFD7596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415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CEE0F7-7052-4728-9483-0E88912FB5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595566-C44E-4660-ACEC-9ECA664F3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A88B59-6439-443A-AF87-447499F7C7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6D7FFD-2764-4549-BEE6-55DF4F4044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D38F4D-B3B6-4262-80B1-945E757C6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779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9597F7-E7BF-4257-9391-80FAD551C6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D25F57-9E46-4BF1-A8ED-F7462612D5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A55B2B-2044-49F5-ACED-E47A78DDD8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474754-BF09-4135-9C5D-5E6B45F87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72A53F-454C-49AE-A60C-9FBDC7884B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FB42F0-4736-4BCF-8004-D0842D139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287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52E2D8-FF71-4093-AAB6-8CF9069274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70998C-2060-406F-A2D9-FB55BD8DD4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A4ADEE-FC38-454B-A94B-8DE6307ACF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3C8585-107B-4B5B-9303-424086E251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DB61BA9-42AA-455B-91B9-B6735FCE40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BDA0F2-1D38-449C-84E4-B61D86322E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3CB382-89F9-4246-9273-910CE29419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5BA66FF-B4B3-4C42-A1E4-3BA99C1BE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053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671A28-BB78-49A9-A1C6-12F73D577B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A0B1CD-343E-45AD-8E65-4BA5C2C00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BE593D-2A62-4060-9BD6-352517425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8F3F8E-E76A-4B80-9ADA-CB2C6AE34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407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8E5A94-12BD-4841-9BC1-2ED3B2B31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C61916-2E49-490D-A466-70E177DF5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0F6506-C4DE-40F5-9B09-CE122D945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529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C3A4C2-73CA-485C-AE0B-89671DA27B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FF1E3D-CA5C-4370-B9CB-089CB1243A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F2CFEC-36CE-4DE6-8F7E-13208C427C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61D669-B389-4638-8EBA-BCDB15B6D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91E858-4B9D-49DB-9BB0-AD944A21A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F41ED7-4C00-4537-9450-0C90F0258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413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2DBA0-2EB7-40FC-98E0-660CF0FE74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E432181-FDBA-4C66-9ABC-1104345B2B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D8B4B3-005E-4253-913C-B466A9EB35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C5C4D9-1B02-4CA5-86B8-7BBE3A3E8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8CB468-3E45-4B04-BB3F-497FAFA16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DA6520-35BE-4C99-90DD-DD9616616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057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D8AD17-8469-4BAE-A464-6AE7F4CC61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FFD2BF-0E34-4844-892E-AECD0679C9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49CFCA-894D-4190-9ABB-2F9E8B47D8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A9EC3-8C02-44AB-8754-9431E1D0D007}" type="datetimeFigureOut">
              <a:rPr lang="en-US" smtClean="0"/>
              <a:t>7/1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9F8E12-DB59-4CF6-9A40-B079B0329D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840DC3-8488-4582-BFE5-6EE1442945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FBE1E3-04C1-4D4B-9C88-FC5C676DE8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455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png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6.png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5.png"/><Relationship Id="rId4" Type="http://schemas.openxmlformats.org/officeDocument/2006/relationships/image" Target="../media/image44.png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7" Type="http://schemas.openxmlformats.org/officeDocument/2006/relationships/image" Target="../media/image4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png"/><Relationship Id="rId5" Type="http://schemas.openxmlformats.org/officeDocument/2006/relationships/image" Target="../media/image47.png"/><Relationship Id="rId4" Type="http://schemas.openxmlformats.org/officeDocument/2006/relationships/image" Target="../media/image46.png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5.png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8.png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7" Type="http://schemas.openxmlformats.org/officeDocument/2006/relationships/image" Target="../media/image70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9.png"/><Relationship Id="rId5" Type="http://schemas.openxmlformats.org/officeDocument/2006/relationships/image" Target="../media/image68.png"/><Relationship Id="rId4" Type="http://schemas.openxmlformats.org/officeDocument/2006/relationships/image" Target="../media/image67.png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2.png"/><Relationship Id="rId4" Type="http://schemas.openxmlformats.org/officeDocument/2006/relationships/image" Target="../media/image71.png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C89BA9-EC1E-497D-8CD9-9930A55D83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. The MS2 in Fig. 4b is a chimera spectru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09A821-0A00-4A71-A44E-85B48B29BE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</a:t>
            </a:r>
            <a:r>
              <a:rPr lang="en-US" sz="2800" dirty="0"/>
              <a:t>himera spectrum of VQASJ[H(9)N(2)</a:t>
            </a:r>
            <a:r>
              <a:rPr lang="en-US" sz="2800" dirty="0" err="1"/>
              <a:t>aH</a:t>
            </a:r>
            <a:r>
              <a:rPr lang="en-US" sz="2800" dirty="0"/>
              <a:t>(1)]WTGTR and 15N-labeled VQASJ[H(10)N(2)]WTGTR</a:t>
            </a:r>
          </a:p>
          <a:p>
            <a:endParaRPr lang="en-US" dirty="0"/>
          </a:p>
          <a:p>
            <a:r>
              <a:rPr lang="en-US" dirty="0"/>
              <a:t>RAW: cwq_mix2-1_726.raw</a:t>
            </a:r>
          </a:p>
          <a:p>
            <a:r>
              <a:rPr lang="en-US" sz="2800" dirty="0"/>
              <a:t>Scan=17948, 3+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312055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5ACE6-F03D-4CA8-AE60-DE06C72BD0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/>
              <a:t>2. Annotated spectra of double-site N-glycopeptides of IgM (Fig. 2d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4378191"/>
            <a:ext cx="10515600" cy="2190115"/>
          </a:xfrm>
        </p:spPr>
        <p:txBody>
          <a:bodyPr>
            <a:normAutofit lnSpcReduction="10000"/>
          </a:bodyPr>
          <a:lstStyle/>
          <a:p>
            <a:r>
              <a:rPr lang="en-US" sz="2000" dirty="0"/>
              <a:t>RAW: 20210408_Std_IgM_NGP_trypsin-chemotrypsin-1.raw</a:t>
            </a:r>
          </a:p>
          <a:p>
            <a:r>
              <a:rPr lang="en-US" sz="2000" dirty="0"/>
              <a:t>Peptide sequence: THTJ(N)ISESHPJ(N)ATF</a:t>
            </a:r>
          </a:p>
          <a:p>
            <a:r>
              <a:rPr lang="en-US" sz="2000" dirty="0"/>
              <a:t>Glycopeptide FDR (“</a:t>
            </a:r>
            <a:r>
              <a:rPr lang="en-US" sz="2000" dirty="0" err="1"/>
              <a:t>TotalFDR</a:t>
            </a:r>
            <a:r>
              <a:rPr lang="en-US" sz="2000" dirty="0"/>
              <a:t>”) &lt;= 0.01</a:t>
            </a:r>
          </a:p>
          <a:p>
            <a:r>
              <a:rPr lang="en-US" sz="2000" dirty="0"/>
              <a:t>SSGL format: J4-Glycan@Prob, J11-Glycan@Prob</a:t>
            </a:r>
          </a:p>
          <a:p>
            <a:pPr lvl="1"/>
            <a:r>
              <a:rPr lang="en-US" sz="1800" dirty="0"/>
              <a:t>No SSGL-Prob cutoffs were applied here; site-groups were removed</a:t>
            </a:r>
          </a:p>
          <a:p>
            <a:pPr lvl="1"/>
            <a:r>
              <a:rPr lang="en-US" sz="1800" dirty="0"/>
              <a:t>Zoom-in regions of key c/z ions for SSGL were displayed in each EThcD spectrum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4CD317B-788D-444D-85D4-74FAB9CE15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3625" y="1574031"/>
            <a:ext cx="7524750" cy="2781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006619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/>
          <a:lstStyle/>
          <a:p>
            <a:r>
              <a:rPr lang="en-US" dirty="0"/>
              <a:t>Spectrum 1</a:t>
            </a:r>
          </a:p>
          <a:p>
            <a:endParaRPr lang="en-US" dirty="0"/>
          </a:p>
          <a:p>
            <a:r>
              <a:rPr lang="en-US" dirty="0"/>
              <a:t>HCD Scan=3507, EThcD Scan=3508</a:t>
            </a:r>
          </a:p>
          <a:p>
            <a:endParaRPr lang="en-US" dirty="0"/>
          </a:p>
          <a:p>
            <a:r>
              <a:rPr lang="en-US" dirty="0"/>
              <a:t>SSGL: J4-H(5)N(5)A(1)F(1)@76%, J11-H(4)N(3)@68%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44689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99" y="0"/>
            <a:ext cx="10972801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7146120" y="182590"/>
            <a:ext cx="34801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9921984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71701ED-9DD0-4302-8253-03FD24EE58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6883"/>
            <a:ext cx="12192000" cy="6089650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C929AEC6-AD7F-4603-9E5F-FD5CAEA47E1D}"/>
              </a:ext>
            </a:extLst>
          </p:cNvPr>
          <p:cNvSpPr/>
          <p:nvPr/>
        </p:nvSpPr>
        <p:spPr>
          <a:xfrm>
            <a:off x="5534082" y="4587043"/>
            <a:ext cx="491748" cy="6183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742D386B-805E-4C0A-BE37-D9EEA13501E6}"/>
              </a:ext>
            </a:extLst>
          </p:cNvPr>
          <p:cNvCxnSpPr>
            <a:cxnSpLocks/>
            <a:stCxn id="28" idx="3"/>
            <a:endCxn id="34" idx="2"/>
          </p:cNvCxnSpPr>
          <p:nvPr/>
        </p:nvCxnSpPr>
        <p:spPr>
          <a:xfrm flipV="1">
            <a:off x="6466114" y="3218731"/>
            <a:ext cx="3001577" cy="16774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6977499" y="422858"/>
            <a:ext cx="5086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DC6E307E-8CE8-4474-82F5-B08372FFD3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69132" y="1952719"/>
            <a:ext cx="3268197" cy="1266012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0D0CC245-FB9F-4A57-8263-3B18197B4721}"/>
              </a:ext>
            </a:extLst>
          </p:cNvPr>
          <p:cNvSpPr txBox="1"/>
          <p:nvPr/>
        </p:nvSpPr>
        <p:spPr>
          <a:xfrm>
            <a:off x="2169132" y="1877303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4 /2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B1D7530-11AC-4F7E-B3EB-AB8CBBFD1109}"/>
              </a:ext>
            </a:extLst>
          </p:cNvPr>
          <p:cNvSpPr txBox="1"/>
          <p:nvPr/>
        </p:nvSpPr>
        <p:spPr>
          <a:xfrm>
            <a:off x="3904750" y="1877303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5 /2+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CE36C52-8195-44BD-8A81-BB2A8B50E516}"/>
              </a:ext>
            </a:extLst>
          </p:cNvPr>
          <p:cNvSpPr txBox="1"/>
          <p:nvPr/>
        </p:nvSpPr>
        <p:spPr>
          <a:xfrm>
            <a:off x="4756339" y="1877303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6 /2+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2D54549E-7952-4C0F-857B-FF313A995BE0}"/>
              </a:ext>
            </a:extLst>
          </p:cNvPr>
          <p:cNvCxnSpPr>
            <a:cxnSpLocks/>
            <a:stCxn id="14" idx="1"/>
            <a:endCxn id="21" idx="2"/>
          </p:cNvCxnSpPr>
          <p:nvPr/>
        </p:nvCxnSpPr>
        <p:spPr>
          <a:xfrm flipH="1" flipV="1">
            <a:off x="3803231" y="3218731"/>
            <a:ext cx="1730851" cy="16774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id="{09BA4F1F-5D5B-4874-AAD6-0790B9B40E66}"/>
              </a:ext>
            </a:extLst>
          </p:cNvPr>
          <p:cNvSpPr/>
          <p:nvPr/>
        </p:nvSpPr>
        <p:spPr>
          <a:xfrm>
            <a:off x="6096000" y="4587043"/>
            <a:ext cx="370114" cy="6183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2E97A38D-4649-4DC0-B7F5-BCF046F1CAC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38727" y="1952719"/>
            <a:ext cx="3057928" cy="1266012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F24F83D4-7332-4C9E-9638-6A630488D878}"/>
              </a:ext>
            </a:extLst>
          </p:cNvPr>
          <p:cNvSpPr txBox="1"/>
          <p:nvPr/>
        </p:nvSpPr>
        <p:spPr>
          <a:xfrm>
            <a:off x="7984513" y="1877303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7 /2+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C54CD58-3784-4634-A16D-F7E81F239042}"/>
              </a:ext>
            </a:extLst>
          </p:cNvPr>
          <p:cNvSpPr txBox="1"/>
          <p:nvPr/>
        </p:nvSpPr>
        <p:spPr>
          <a:xfrm>
            <a:off x="9793789" y="1877302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8 /2+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1A99CF9-5514-46A3-8E11-F334170547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1645473"/>
              </p:ext>
            </p:extLst>
          </p:nvPr>
        </p:nvGraphicFramePr>
        <p:xfrm>
          <a:off x="372254" y="6291949"/>
          <a:ext cx="4876800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7451169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7009626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06548290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73189044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59595020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84501858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80523743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264866439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ragm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2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3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4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c5 2+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c6 2+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c7 2+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c8 2+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61050497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/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6.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7.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367.53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424.05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467.56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532.09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575.63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5240112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1678790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/>
          <a:lstStyle/>
          <a:p>
            <a:r>
              <a:rPr lang="en-US" dirty="0"/>
              <a:t>Spectrum 2</a:t>
            </a:r>
          </a:p>
          <a:p>
            <a:endParaRPr lang="en-US" dirty="0"/>
          </a:p>
          <a:p>
            <a:r>
              <a:rPr lang="en-US" dirty="0"/>
              <a:t>HCD Scan=3481, EThcD Scan=3482</a:t>
            </a:r>
          </a:p>
          <a:p>
            <a:endParaRPr lang="en-US" dirty="0"/>
          </a:p>
          <a:p>
            <a:r>
              <a:rPr lang="en-US" dirty="0"/>
              <a:t>SSGL: </a:t>
            </a:r>
            <a:r>
              <a:rPr lang="en-US" dirty="0">
                <a:solidFill>
                  <a:srgbClr val="FF0000"/>
                </a:solidFill>
              </a:rPr>
              <a:t>J4-H(4)N(2)F(1)@70%, J11-H(6)N(5)A(1)@69%</a:t>
            </a:r>
          </a:p>
          <a:p>
            <a:pPr lvl="1"/>
            <a:r>
              <a:rPr lang="en-US" altLang="zh-CN" dirty="0">
                <a:solidFill>
                  <a:srgbClr val="FF0000"/>
                </a:solidFill>
              </a:rPr>
              <a:t>× </a:t>
            </a:r>
            <a:r>
              <a:rPr lang="en-US" dirty="0"/>
              <a:t>These localized glycans were not confirmed by </a:t>
            </a:r>
            <a:r>
              <a:rPr lang="en-US" dirty="0" err="1"/>
              <a:t>GluC</a:t>
            </a:r>
            <a:r>
              <a:rPr lang="en-US" dirty="0"/>
              <a:t> digestion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51709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599" y="0"/>
            <a:ext cx="1097280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7146120" y="182590"/>
            <a:ext cx="34801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151470643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F7BD636F-5EFB-4E37-A577-0668E3F644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2072"/>
            <a:ext cx="12192000" cy="6089650"/>
          </a:xfrm>
          <a:prstGeom prst="rect">
            <a:avLst/>
          </a:prstGeom>
        </p:spPr>
      </p:pic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742D386B-805E-4C0A-BE37-D9EEA13501E6}"/>
              </a:ext>
            </a:extLst>
          </p:cNvPr>
          <p:cNvCxnSpPr>
            <a:cxnSpLocks/>
            <a:endCxn id="13" idx="3"/>
          </p:cNvCxnSpPr>
          <p:nvPr/>
        </p:nvCxnSpPr>
        <p:spPr>
          <a:xfrm flipH="1">
            <a:off x="6669024" y="2513725"/>
            <a:ext cx="707138" cy="2292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0637B38-CB40-43BC-B39E-3569F9A601CF}"/>
              </a:ext>
            </a:extLst>
          </p:cNvPr>
          <p:cNvCxnSpPr>
            <a:cxnSpLocks/>
            <a:endCxn id="15" idx="1"/>
          </p:cNvCxnSpPr>
          <p:nvPr/>
        </p:nvCxnSpPr>
        <p:spPr>
          <a:xfrm flipV="1">
            <a:off x="8400639" y="2117463"/>
            <a:ext cx="717047" cy="39626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13E29A5D-347A-4C57-81D9-9C2A56EEE09C}"/>
              </a:ext>
            </a:extLst>
          </p:cNvPr>
          <p:cNvSpPr txBox="1"/>
          <p:nvPr/>
        </p:nvSpPr>
        <p:spPr>
          <a:xfrm>
            <a:off x="9117686" y="1532687"/>
            <a:ext cx="280240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5/1+ and Y-H(4)N(6)F(1)/2+ overlapped. </a:t>
            </a:r>
            <a:r>
              <a:rPr lang="en-US" sz="1400" dirty="0" err="1"/>
              <a:t>gLabel</a:t>
            </a:r>
            <a:r>
              <a:rPr lang="en-US" sz="1400" dirty="0"/>
              <a:t> does not check overlapped ions. But </a:t>
            </a:r>
            <a:r>
              <a:rPr lang="en-US" sz="1400" dirty="0" err="1"/>
              <a:t>pGlycoSite</a:t>
            </a:r>
            <a:r>
              <a:rPr lang="en-US" sz="1400" dirty="0"/>
              <a:t> will not consider this ion because Y and b/y ions are removed before SSGL.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4324F72-5B98-4DEC-9BD9-258F424C2D18}"/>
              </a:ext>
            </a:extLst>
          </p:cNvPr>
          <p:cNvSpPr txBox="1"/>
          <p:nvPr/>
        </p:nvSpPr>
        <p:spPr>
          <a:xfrm>
            <a:off x="6977499" y="500683"/>
            <a:ext cx="5086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10701FA4-068D-4985-AC05-E6C714C3F9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362028"/>
              </p:ext>
            </p:extLst>
          </p:nvPr>
        </p:nvGraphicFramePr>
        <p:xfrm>
          <a:off x="401689" y="6308454"/>
          <a:ext cx="3048000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72175167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89438948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47290236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40194865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368332711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ragm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2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3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10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z8 2+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08444248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/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6.1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7.1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683.16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583.094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738917858"/>
                  </a:ext>
                </a:extLst>
              </a:tr>
            </a:tbl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6040A117-9627-462A-BD20-97E223BFA7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96722" y="1709912"/>
            <a:ext cx="1710061" cy="179613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89A8B09-BC4D-426A-8E2D-4BE0ABDBFA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72468" y="2085306"/>
            <a:ext cx="1796556" cy="1315294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ADC4853-563B-4FEB-B66E-C4A406E33F90}"/>
              </a:ext>
            </a:extLst>
          </p:cNvPr>
          <p:cNvSpPr txBox="1"/>
          <p:nvPr/>
        </p:nvSpPr>
        <p:spPr>
          <a:xfrm>
            <a:off x="5857086" y="2106596"/>
            <a:ext cx="5741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z8 /2+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7F22C32-3A10-4128-87E4-237DDCE76586}"/>
              </a:ext>
            </a:extLst>
          </p:cNvPr>
          <p:cNvCxnSpPr>
            <a:cxnSpLocks/>
            <a:stCxn id="19" idx="1"/>
          </p:cNvCxnSpPr>
          <p:nvPr/>
        </p:nvCxnSpPr>
        <p:spPr>
          <a:xfrm flipH="1">
            <a:off x="4010004" y="2245096"/>
            <a:ext cx="1847082" cy="6344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5" name="Picture 24">
            <a:extLst>
              <a:ext uri="{FF2B5EF4-FFF2-40B4-BE49-F238E27FC236}">
                <a16:creationId xmlns:a16="http://schemas.microsoft.com/office/drawing/2014/main" id="{763B632B-6AB4-4785-A296-1EA5633EF8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71319" y="3146897"/>
            <a:ext cx="1192139" cy="1011381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5BC466B6-4EC4-4EBE-A108-A9CC824A3A55}"/>
              </a:ext>
            </a:extLst>
          </p:cNvPr>
          <p:cNvSpPr/>
          <p:nvPr/>
        </p:nvSpPr>
        <p:spPr>
          <a:xfrm>
            <a:off x="7827524" y="4873560"/>
            <a:ext cx="158886" cy="25403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12209B4C-DF74-472A-95F0-F92E4B84833F}"/>
              </a:ext>
            </a:extLst>
          </p:cNvPr>
          <p:cNvCxnSpPr>
            <a:cxnSpLocks/>
            <a:stCxn id="26" idx="3"/>
            <a:endCxn id="25" idx="2"/>
          </p:cNvCxnSpPr>
          <p:nvPr/>
        </p:nvCxnSpPr>
        <p:spPr>
          <a:xfrm flipV="1">
            <a:off x="7986410" y="4158278"/>
            <a:ext cx="1880979" cy="8422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1" name="Picture 30">
            <a:extLst>
              <a:ext uri="{FF2B5EF4-FFF2-40B4-BE49-F238E27FC236}">
                <a16:creationId xmlns:a16="http://schemas.microsoft.com/office/drawing/2014/main" id="{C9A1A1E3-ADD7-489A-9ADC-604B2CB2FE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584312" y="2980980"/>
            <a:ext cx="1529864" cy="1559667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D3B0CBBA-E52B-4979-B957-F5F8CDB4EC75}"/>
              </a:ext>
            </a:extLst>
          </p:cNvPr>
          <p:cNvSpPr txBox="1"/>
          <p:nvPr/>
        </p:nvSpPr>
        <p:spPr>
          <a:xfrm>
            <a:off x="9617605" y="3214957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z10 /2+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F6264B5A-A74C-4B84-A258-CE17266996E5}"/>
              </a:ext>
            </a:extLst>
          </p:cNvPr>
          <p:cNvCxnSpPr>
            <a:cxnSpLocks/>
            <a:stCxn id="32" idx="2"/>
            <a:endCxn id="31" idx="1"/>
          </p:cNvCxnSpPr>
          <p:nvPr/>
        </p:nvCxnSpPr>
        <p:spPr>
          <a:xfrm>
            <a:off x="9943977" y="3491956"/>
            <a:ext cx="640335" cy="26885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4968639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/>
          <a:lstStyle/>
          <a:p>
            <a:r>
              <a:rPr lang="en-US" dirty="0"/>
              <a:t>Spectrum 3</a:t>
            </a:r>
          </a:p>
          <a:p>
            <a:endParaRPr lang="en-US" dirty="0"/>
          </a:p>
          <a:p>
            <a:r>
              <a:rPr lang="en-US" dirty="0"/>
              <a:t>HCD Scan=3915, EThcD Scan=3916</a:t>
            </a:r>
          </a:p>
          <a:p>
            <a:endParaRPr lang="en-US" dirty="0"/>
          </a:p>
          <a:p>
            <a:r>
              <a:rPr lang="en-US" dirty="0"/>
              <a:t>SSGL: J4-H(5)N(5)A(2)F(1)@85%, J11-H(5)N(2)@84%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299678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599" y="0"/>
            <a:ext cx="1097280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7146120" y="182590"/>
            <a:ext cx="34801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231608553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62711ED-802F-4CB0-AC84-F10A6C8CBB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0977"/>
            <a:ext cx="12192000" cy="608965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AF446EE-A88B-459C-8E39-119CDCED198D}"/>
              </a:ext>
            </a:extLst>
          </p:cNvPr>
          <p:cNvSpPr txBox="1"/>
          <p:nvPr/>
        </p:nvSpPr>
        <p:spPr>
          <a:xfrm>
            <a:off x="6977499" y="539588"/>
            <a:ext cx="5086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D2A62C8-83E4-4C55-B5D7-FD3E3B25BA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34076" y="1912070"/>
            <a:ext cx="4420111" cy="1677706"/>
          </a:xfrm>
          <a:prstGeom prst="rect">
            <a:avLst/>
          </a:prstGeom>
          <a:ln>
            <a:solidFill>
              <a:schemeClr val="dk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FFE25CB-81A6-4DBE-A385-FEF31F1BC1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37342" y="1575900"/>
            <a:ext cx="922513" cy="672340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7FE6A05B-F43A-4C7B-BDDE-EDE617D8DF76}"/>
              </a:ext>
            </a:extLst>
          </p:cNvPr>
          <p:cNvSpPr txBox="1"/>
          <p:nvPr/>
        </p:nvSpPr>
        <p:spPr>
          <a:xfrm>
            <a:off x="2446734" y="1904707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4 /2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66FF73-6FBE-4081-91E8-596F13067F52}"/>
              </a:ext>
            </a:extLst>
          </p:cNvPr>
          <p:cNvSpPr txBox="1"/>
          <p:nvPr/>
        </p:nvSpPr>
        <p:spPr>
          <a:xfrm>
            <a:off x="6276273" y="1904708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6 /2+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FEF0EB8-1D22-4DEA-8473-3689761B25B0}"/>
              </a:ext>
            </a:extLst>
          </p:cNvPr>
          <p:cNvSpPr/>
          <p:nvPr/>
        </p:nvSpPr>
        <p:spPr>
          <a:xfrm>
            <a:off x="7068684" y="4648114"/>
            <a:ext cx="659984" cy="53942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0F9E6BFF-CA17-4513-BB26-FE3F8BCEF1A9}"/>
              </a:ext>
            </a:extLst>
          </p:cNvPr>
          <p:cNvCxnSpPr>
            <a:cxnSpLocks/>
            <a:stCxn id="19" idx="1"/>
            <a:endCxn id="10" idx="2"/>
          </p:cNvCxnSpPr>
          <p:nvPr/>
        </p:nvCxnSpPr>
        <p:spPr>
          <a:xfrm flipH="1" flipV="1">
            <a:off x="4644132" y="3589776"/>
            <a:ext cx="2424552" cy="132805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4B4BCD5C-4B5B-4C05-A42C-6C387A8210C2}"/>
              </a:ext>
            </a:extLst>
          </p:cNvPr>
          <p:cNvCxnSpPr>
            <a:cxnSpLocks/>
            <a:endCxn id="12" idx="2"/>
          </p:cNvCxnSpPr>
          <p:nvPr/>
        </p:nvCxnSpPr>
        <p:spPr>
          <a:xfrm flipV="1">
            <a:off x="8110789" y="2248240"/>
            <a:ext cx="387810" cy="3889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427DEB22-D430-412B-83D0-80D61CE6B3B2}"/>
              </a:ext>
            </a:extLst>
          </p:cNvPr>
          <p:cNvSpPr txBox="1"/>
          <p:nvPr/>
        </p:nvSpPr>
        <p:spPr>
          <a:xfrm>
            <a:off x="8037342" y="1555912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8 /2+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C94447FF-A4F7-48A4-B9BF-34546D6D9C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89754" y="3734443"/>
            <a:ext cx="1474760" cy="609599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AC4ED2F7-700C-46E2-8A88-B6644FB0F9D8}"/>
              </a:ext>
            </a:extLst>
          </p:cNvPr>
          <p:cNvSpPr txBox="1"/>
          <p:nvPr/>
        </p:nvSpPr>
        <p:spPr>
          <a:xfrm>
            <a:off x="8075442" y="3757303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z7+H /1+</a:t>
            </a:r>
            <a:endParaRPr lang="en-US" sz="1400" dirty="0"/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942A38A3-4A65-473C-8C62-FD64B2BFF9CD}"/>
              </a:ext>
            </a:extLst>
          </p:cNvPr>
          <p:cNvCxnSpPr>
            <a:cxnSpLocks/>
          </p:cNvCxnSpPr>
          <p:nvPr/>
        </p:nvCxnSpPr>
        <p:spPr>
          <a:xfrm flipH="1">
            <a:off x="8677085" y="2248240"/>
            <a:ext cx="377223" cy="14862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7" name="Picture 36">
            <a:extLst>
              <a:ext uri="{FF2B5EF4-FFF2-40B4-BE49-F238E27FC236}">
                <a16:creationId xmlns:a16="http://schemas.microsoft.com/office/drawing/2014/main" id="{5C346E9A-8707-4DD9-A840-667330C4F7B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72869"/>
          <a:stretch/>
        </p:blipFill>
        <p:spPr>
          <a:xfrm>
            <a:off x="10143010" y="1710868"/>
            <a:ext cx="1184988" cy="1003229"/>
          </a:xfrm>
          <a:prstGeom prst="rect">
            <a:avLst/>
          </a:prstGeom>
          <a:ln>
            <a:solidFill>
              <a:schemeClr val="dk1"/>
            </a:solidFill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5521F52C-DB98-48A4-973A-CE2EF0BCF13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8292"/>
          <a:stretch/>
        </p:blipFill>
        <p:spPr>
          <a:xfrm>
            <a:off x="10170527" y="3497647"/>
            <a:ext cx="1184988" cy="1253833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57B23DF5-54F8-4C79-9DBE-BD122D33A2BF}"/>
              </a:ext>
            </a:extLst>
          </p:cNvPr>
          <p:cNvSpPr txBox="1"/>
          <p:nvPr/>
        </p:nvSpPr>
        <p:spPr>
          <a:xfrm>
            <a:off x="10208627" y="1700824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z8+H /1+</a:t>
            </a:r>
            <a:endParaRPr lang="en-US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8E9420B-CC06-4F78-9870-01E7731229DA}"/>
              </a:ext>
            </a:extLst>
          </p:cNvPr>
          <p:cNvSpPr txBox="1"/>
          <p:nvPr/>
        </p:nvSpPr>
        <p:spPr>
          <a:xfrm>
            <a:off x="10414367" y="3467167"/>
            <a:ext cx="636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z9 /1+</a:t>
            </a:r>
            <a:endParaRPr lang="en-US" sz="1400" dirty="0"/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EB715601-EE17-44F4-9F06-2106027EA13F}"/>
              </a:ext>
            </a:extLst>
          </p:cNvPr>
          <p:cNvCxnSpPr>
            <a:cxnSpLocks/>
            <a:endCxn id="37" idx="1"/>
          </p:cNvCxnSpPr>
          <p:nvPr/>
        </p:nvCxnSpPr>
        <p:spPr>
          <a:xfrm>
            <a:off x="9757924" y="2008601"/>
            <a:ext cx="385086" cy="2038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DA6F664E-E697-4247-B4C5-164A13411E88}"/>
              </a:ext>
            </a:extLst>
          </p:cNvPr>
          <p:cNvCxnSpPr>
            <a:cxnSpLocks/>
            <a:endCxn id="40" idx="0"/>
          </p:cNvCxnSpPr>
          <p:nvPr/>
        </p:nvCxnSpPr>
        <p:spPr>
          <a:xfrm>
            <a:off x="10106142" y="2873957"/>
            <a:ext cx="626582" cy="5932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B07F152-697D-4E94-8AD3-DB2B1A54E1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8316429"/>
              </p:ext>
            </p:extLst>
          </p:nvPr>
        </p:nvGraphicFramePr>
        <p:xfrm>
          <a:off x="285345" y="6325283"/>
          <a:ext cx="6096000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81472708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82099549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02865638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98379467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80963225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74316057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54220896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69561268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88033006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220449749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ragm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2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3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4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6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c8 2+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11 2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9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8+H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7+H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06968740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/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6.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7.1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1513.061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1613.119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721.138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03.4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2189.799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2103.772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974.767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360464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8335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254E3498-96D6-4BC6-ADC8-14542C65FA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19644"/>
            <a:ext cx="12186662" cy="614141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D678DA5-5A38-4C98-B003-7DB449AA31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24530" y="2106949"/>
            <a:ext cx="3355348" cy="1052195"/>
          </a:xfrm>
          <a:prstGeom prst="rect">
            <a:avLst/>
          </a:prstGeom>
          <a:ln w="12700">
            <a:solidFill>
              <a:schemeClr val="tx1">
                <a:lumMod val="65000"/>
                <a:lumOff val="35000"/>
              </a:schemeClr>
            </a:solidFill>
          </a:ln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C0FCD0B0-5471-4E2C-BE9E-B5179BB16F2D}"/>
              </a:ext>
            </a:extLst>
          </p:cNvPr>
          <p:cNvSpPr/>
          <p:nvPr/>
        </p:nvSpPr>
        <p:spPr>
          <a:xfrm>
            <a:off x="2271152" y="2994660"/>
            <a:ext cx="419100" cy="506845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6FDB904C-4F8F-4575-9F25-10D2ABBFAE57}"/>
              </a:ext>
            </a:extLst>
          </p:cNvPr>
          <p:cNvCxnSpPr>
            <a:cxnSpLocks/>
            <a:stCxn id="15" idx="0"/>
            <a:endCxn id="14" idx="1"/>
          </p:cNvCxnSpPr>
          <p:nvPr/>
        </p:nvCxnSpPr>
        <p:spPr>
          <a:xfrm flipV="1">
            <a:off x="2480702" y="2633047"/>
            <a:ext cx="1643828" cy="361613"/>
          </a:xfrm>
          <a:prstGeom prst="straightConnector1">
            <a:avLst/>
          </a:prstGeom>
          <a:ln w="19050">
            <a:headEnd w="sm" len="sm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CC029928-E526-42A4-B017-7CE082034F39}"/>
              </a:ext>
            </a:extLst>
          </p:cNvPr>
          <p:cNvCxnSpPr>
            <a:cxnSpLocks/>
          </p:cNvCxnSpPr>
          <p:nvPr/>
        </p:nvCxnSpPr>
        <p:spPr>
          <a:xfrm flipV="1">
            <a:off x="4815258" y="1974413"/>
            <a:ext cx="0" cy="433507"/>
          </a:xfrm>
          <a:prstGeom prst="straightConnector1">
            <a:avLst/>
          </a:prstGeom>
          <a:ln w="19050">
            <a:headEnd w="sm" len="sm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10E80E89-682A-4FCE-8E1A-92956A8FBBD1}"/>
              </a:ext>
            </a:extLst>
          </p:cNvPr>
          <p:cNvSpPr txBox="1"/>
          <p:nvPr/>
        </p:nvSpPr>
        <p:spPr>
          <a:xfrm>
            <a:off x="4449497" y="1521856"/>
            <a:ext cx="303038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ono-isotopic peak of </a:t>
            </a:r>
          </a:p>
          <a:p>
            <a:r>
              <a:rPr lang="en-US" sz="1400" dirty="0"/>
              <a:t>15N-labeled </a:t>
            </a:r>
            <a:r>
              <a:rPr lang="pt-BR" sz="1400" dirty="0"/>
              <a:t>VQASJ[H(10)N(2)]WTGTR </a:t>
            </a:r>
            <a:r>
              <a:rPr lang="en-US" sz="1400" dirty="0"/>
              <a:t>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78FD52C-05BA-4ADA-8530-3C00D0780C58}"/>
              </a:ext>
            </a:extLst>
          </p:cNvPr>
          <p:cNvSpPr txBox="1"/>
          <p:nvPr/>
        </p:nvSpPr>
        <p:spPr>
          <a:xfrm>
            <a:off x="8323868" y="650449"/>
            <a:ext cx="1689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1 annotation</a:t>
            </a:r>
          </a:p>
        </p:txBody>
      </p:sp>
    </p:spTree>
    <p:extLst>
      <p:ext uri="{BB962C8B-B14F-4D97-AF65-F5344CB8AC3E}">
        <p14:creationId xmlns:p14="http://schemas.microsoft.com/office/powerpoint/2010/main" val="321498612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/>
          <a:lstStyle/>
          <a:p>
            <a:r>
              <a:rPr lang="en-US" dirty="0"/>
              <a:t>Spectrum 4</a:t>
            </a:r>
          </a:p>
          <a:p>
            <a:endParaRPr lang="en-US" dirty="0"/>
          </a:p>
          <a:p>
            <a:r>
              <a:rPr lang="en-US" dirty="0"/>
              <a:t>HCD Scan=3107, EThcD Scan=3108</a:t>
            </a:r>
          </a:p>
          <a:p>
            <a:endParaRPr lang="en-US" dirty="0"/>
          </a:p>
          <a:p>
            <a:r>
              <a:rPr lang="en-US" dirty="0"/>
              <a:t>SSGL: J4-H(4)N(5)F(1)@68%, J11-H(6)N(2)@68%</a:t>
            </a:r>
          </a:p>
          <a:p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863347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599" y="0"/>
            <a:ext cx="1097280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7146120" y="182590"/>
            <a:ext cx="34801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29459263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A3F2E627-C097-4F75-8701-405A239DF3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31259"/>
            <a:ext cx="12192000" cy="60896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6977499" y="529870"/>
            <a:ext cx="5086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028DAA7-02D9-4BA0-B977-577887A813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23646" y="1468251"/>
            <a:ext cx="2725254" cy="1932276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51D78FE8-A6BD-42E9-8847-537591CA1CC1}"/>
              </a:ext>
            </a:extLst>
          </p:cNvPr>
          <p:cNvSpPr txBox="1"/>
          <p:nvPr/>
        </p:nvSpPr>
        <p:spPr>
          <a:xfrm>
            <a:off x="8994306" y="1540794"/>
            <a:ext cx="636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z9 /1+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963EE92-0D0B-4297-ACC0-70DA84E82C9C}"/>
              </a:ext>
            </a:extLst>
          </p:cNvPr>
          <p:cNvSpPr txBox="1"/>
          <p:nvPr/>
        </p:nvSpPr>
        <p:spPr>
          <a:xfrm>
            <a:off x="7782726" y="2155504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4 /1+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07550FC-1832-4514-9E11-687A8D3D323A}"/>
              </a:ext>
            </a:extLst>
          </p:cNvPr>
          <p:cNvSpPr/>
          <p:nvPr/>
        </p:nvSpPr>
        <p:spPr>
          <a:xfrm>
            <a:off x="10274466" y="4349564"/>
            <a:ext cx="659984" cy="8458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AE88EDE-358F-4D35-A2B6-12C5EDC3ADF3}"/>
              </a:ext>
            </a:extLst>
          </p:cNvPr>
          <p:cNvCxnSpPr>
            <a:cxnSpLocks/>
            <a:endCxn id="3" idx="2"/>
          </p:cNvCxnSpPr>
          <p:nvPr/>
        </p:nvCxnSpPr>
        <p:spPr>
          <a:xfrm flipH="1" flipV="1">
            <a:off x="8886273" y="3400527"/>
            <a:ext cx="1720768" cy="9490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779FD30-A9B3-4F81-9DC1-7D680BE5BC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3787574"/>
              </p:ext>
            </p:extLst>
          </p:nvPr>
        </p:nvGraphicFramePr>
        <p:xfrm>
          <a:off x="330740" y="6275118"/>
          <a:ext cx="3048000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100572534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1671172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33414590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81179578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617174547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ragm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2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3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4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z9 1+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87475135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/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6.1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7.1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2280.874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2351.902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9457400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7513814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/>
          <a:lstStyle/>
          <a:p>
            <a:r>
              <a:rPr lang="en-US" dirty="0"/>
              <a:t>Spectrum 5</a:t>
            </a:r>
          </a:p>
          <a:p>
            <a:endParaRPr lang="en-US" dirty="0"/>
          </a:p>
          <a:p>
            <a:r>
              <a:rPr lang="en-US" dirty="0"/>
              <a:t>HCD Scan=3077, EThcD Scan=3078</a:t>
            </a:r>
          </a:p>
          <a:p>
            <a:endParaRPr lang="en-US" dirty="0"/>
          </a:p>
          <a:p>
            <a:r>
              <a:rPr lang="en-US" dirty="0"/>
              <a:t>SSGL: J4-H(5)N(2)F(1)@68%, </a:t>
            </a:r>
            <a:r>
              <a:rPr lang="en-US" altLang="zh-CN" dirty="0">
                <a:solidFill>
                  <a:srgbClr val="FF0000"/>
                </a:solidFill>
              </a:rPr>
              <a:t>× </a:t>
            </a:r>
            <a:r>
              <a:rPr lang="en-US" dirty="0">
                <a:solidFill>
                  <a:srgbClr val="FF0000"/>
                </a:solidFill>
              </a:rPr>
              <a:t>J11-H(6)N(5)@75%</a:t>
            </a:r>
          </a:p>
          <a:p>
            <a:pPr lvl="1"/>
            <a:r>
              <a:rPr lang="en-US" altLang="zh-CN" dirty="0">
                <a:solidFill>
                  <a:srgbClr val="FF0000"/>
                </a:solidFill>
              </a:rPr>
              <a:t>× </a:t>
            </a:r>
            <a:r>
              <a:rPr lang="en-US" dirty="0"/>
              <a:t>The localized glycan was not confirmed by </a:t>
            </a:r>
            <a:r>
              <a:rPr lang="en-US" dirty="0" err="1"/>
              <a:t>GluC</a:t>
            </a:r>
            <a:r>
              <a:rPr lang="en-US" dirty="0"/>
              <a:t> digestion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7147765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599" y="0"/>
            <a:ext cx="10972800" cy="68579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7146120" y="182590"/>
            <a:ext cx="34801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325573296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393ACA0-D2D5-4F8E-884B-4FE3942A6C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0984"/>
            <a:ext cx="12192000" cy="60896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6977499" y="539595"/>
            <a:ext cx="5086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07550FC-1832-4514-9E11-687A8D3D323A}"/>
              </a:ext>
            </a:extLst>
          </p:cNvPr>
          <p:cNvSpPr/>
          <p:nvPr/>
        </p:nvSpPr>
        <p:spPr>
          <a:xfrm>
            <a:off x="9867900" y="4359289"/>
            <a:ext cx="1409700" cy="85344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AE88EDE-358F-4D35-A2B6-12C5EDC3ADF3}"/>
              </a:ext>
            </a:extLst>
          </p:cNvPr>
          <p:cNvCxnSpPr>
            <a:cxnSpLocks/>
            <a:endCxn id="6" idx="3"/>
          </p:cNvCxnSpPr>
          <p:nvPr/>
        </p:nvCxnSpPr>
        <p:spPr>
          <a:xfrm flipH="1" flipV="1">
            <a:off x="7782726" y="2634108"/>
            <a:ext cx="2824316" cy="17251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" name="Picture 5">
            <a:extLst>
              <a:ext uri="{FF2B5EF4-FFF2-40B4-BE49-F238E27FC236}">
                <a16:creationId xmlns:a16="http://schemas.microsoft.com/office/drawing/2014/main" id="{FEF2B7D4-0AEA-49F3-A52D-9A9E59839A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3114" y="1841233"/>
            <a:ext cx="4519612" cy="1585749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63F0030-5D41-45A0-A7E3-67FEDCFF63E0}"/>
              </a:ext>
            </a:extLst>
          </p:cNvPr>
          <p:cNvSpPr txBox="1"/>
          <p:nvPr/>
        </p:nvSpPr>
        <p:spPr>
          <a:xfrm>
            <a:off x="6832719" y="1929893"/>
            <a:ext cx="838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z4+H /1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6B5AC48-1138-4443-B1ED-8FAAA7BE13DC}"/>
              </a:ext>
            </a:extLst>
          </p:cNvPr>
          <p:cNvSpPr txBox="1"/>
          <p:nvPr/>
        </p:nvSpPr>
        <p:spPr>
          <a:xfrm>
            <a:off x="3388479" y="1940385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7 /1+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16D5FE6-2137-4904-944E-59E70758EC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1822310"/>
              </p:ext>
            </p:extLst>
          </p:nvPr>
        </p:nvGraphicFramePr>
        <p:xfrm>
          <a:off x="466928" y="6297762"/>
          <a:ext cx="3048000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185481656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43112420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60583053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8530259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83811753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ragm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2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3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7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4+H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37671306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/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6.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7.1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2162.889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2424.882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3881509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0829637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/>
          <a:lstStyle/>
          <a:p>
            <a:r>
              <a:rPr lang="en-US" dirty="0"/>
              <a:t>Spectrum 6</a:t>
            </a:r>
          </a:p>
          <a:p>
            <a:endParaRPr lang="en-US" dirty="0"/>
          </a:p>
          <a:p>
            <a:r>
              <a:rPr lang="en-US" dirty="0"/>
              <a:t>HCD Scan=3082, EThcD Scan=3083</a:t>
            </a:r>
          </a:p>
          <a:p>
            <a:endParaRPr lang="en-US" dirty="0"/>
          </a:p>
          <a:p>
            <a:r>
              <a:rPr lang="en-US" dirty="0"/>
              <a:t>SSGL: J4-H(5)N(5)F(1)@74%, J11-H(6)N(2)@76%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829088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600" y="0"/>
            <a:ext cx="10972798" cy="68579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7146120" y="182590"/>
            <a:ext cx="34801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12066784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3E5DDE7-8AE8-4E19-B9D5-803069748F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21527"/>
            <a:ext cx="12192000" cy="60896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6977499" y="520138"/>
            <a:ext cx="5086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07550FC-1832-4514-9E11-687A8D3D323A}"/>
              </a:ext>
            </a:extLst>
          </p:cNvPr>
          <p:cNvSpPr/>
          <p:nvPr/>
        </p:nvSpPr>
        <p:spPr>
          <a:xfrm>
            <a:off x="5768340" y="4309352"/>
            <a:ext cx="990600" cy="85344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DF91E4B-CBCB-40A2-B566-2D496441D9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86000" y="2869555"/>
            <a:ext cx="3566160" cy="1403726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33BA345-408A-4261-9619-A564F7DCBE53}"/>
              </a:ext>
            </a:extLst>
          </p:cNvPr>
          <p:cNvSpPr txBox="1"/>
          <p:nvPr/>
        </p:nvSpPr>
        <p:spPr>
          <a:xfrm>
            <a:off x="2301240" y="2816215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4 /2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3D07FEB-8053-4833-BCB9-CF3F9A265983}"/>
              </a:ext>
            </a:extLst>
          </p:cNvPr>
          <p:cNvSpPr txBox="1"/>
          <p:nvPr/>
        </p:nvSpPr>
        <p:spPr>
          <a:xfrm>
            <a:off x="3870960" y="2816215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6 /2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313D5E4-22FF-475B-8090-B3EB0DEB2DCD}"/>
              </a:ext>
            </a:extLst>
          </p:cNvPr>
          <p:cNvSpPr txBox="1"/>
          <p:nvPr/>
        </p:nvSpPr>
        <p:spPr>
          <a:xfrm>
            <a:off x="5174701" y="2816214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7 /2+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73126E72-18F1-48A6-B6AB-63BE837E6D86}"/>
              </a:ext>
            </a:extLst>
          </p:cNvPr>
          <p:cNvCxnSpPr>
            <a:cxnSpLocks/>
            <a:stCxn id="29" idx="1"/>
            <a:endCxn id="9" idx="2"/>
          </p:cNvCxnSpPr>
          <p:nvPr/>
        </p:nvCxnSpPr>
        <p:spPr>
          <a:xfrm flipH="1" flipV="1">
            <a:off x="4069080" y="4273281"/>
            <a:ext cx="1699260" cy="46279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C4685D8-5E5C-463B-BA41-BE3895548D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1192707"/>
              </p:ext>
            </p:extLst>
          </p:nvPr>
        </p:nvGraphicFramePr>
        <p:xfrm>
          <a:off x="398834" y="6259692"/>
          <a:ext cx="4876800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11967573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19076112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98068916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382764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60294434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63311445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56773445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89770387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ragm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2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c3 1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4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6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7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13 2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z3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29903072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/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6.1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7.1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1221.982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322.028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386.538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379.4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322.15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3083162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3176835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/>
          <a:lstStyle/>
          <a:p>
            <a:r>
              <a:rPr lang="en-US" dirty="0"/>
              <a:t>Spectrum 7</a:t>
            </a:r>
          </a:p>
          <a:p>
            <a:endParaRPr lang="en-US" dirty="0"/>
          </a:p>
          <a:p>
            <a:r>
              <a:rPr lang="en-US" dirty="0"/>
              <a:t>HCD Scan=3068, EThcD Scan=3069</a:t>
            </a:r>
          </a:p>
          <a:p>
            <a:endParaRPr lang="en-US" dirty="0"/>
          </a:p>
          <a:p>
            <a:r>
              <a:rPr lang="en-US" dirty="0"/>
              <a:t>SSGL: J4-H(5)N(5)F(1)@86%, J11-H(7)N(2)@86%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82108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83EC30C-4F54-44F0-8CB5-C1378E29C3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37383"/>
            <a:ext cx="12192000" cy="611521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D7AF4DA-C370-436C-85C2-5A6DDDD02E3A}"/>
              </a:ext>
            </a:extLst>
          </p:cNvPr>
          <p:cNvSpPr txBox="1"/>
          <p:nvPr/>
        </p:nvSpPr>
        <p:spPr>
          <a:xfrm>
            <a:off x="5720672" y="665838"/>
            <a:ext cx="11993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15N-labeled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13F38DA-5741-4152-80DF-DDCEA5E64E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56192" y="1796806"/>
            <a:ext cx="3079616" cy="1125248"/>
          </a:xfrm>
          <a:prstGeom prst="rect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9CDB77AA-BC79-43E6-92D5-72E92CF1406D}"/>
              </a:ext>
            </a:extLst>
          </p:cNvPr>
          <p:cNvSpPr/>
          <p:nvPr/>
        </p:nvSpPr>
        <p:spPr>
          <a:xfrm>
            <a:off x="3169285" y="3071863"/>
            <a:ext cx="452755" cy="423126"/>
          </a:xfrm>
          <a:prstGeom prst="rect">
            <a:avLst/>
          </a:prstGeom>
          <a:noFill/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92D70236-1150-4794-A9F5-C2A31F264C7A}"/>
              </a:ext>
            </a:extLst>
          </p:cNvPr>
          <p:cNvCxnSpPr>
            <a:cxnSpLocks/>
            <a:stCxn id="8" idx="0"/>
            <a:endCxn id="7" idx="1"/>
          </p:cNvCxnSpPr>
          <p:nvPr/>
        </p:nvCxnSpPr>
        <p:spPr>
          <a:xfrm flipV="1">
            <a:off x="3395663" y="2359430"/>
            <a:ext cx="1160529" cy="712433"/>
          </a:xfrm>
          <a:prstGeom prst="straightConnector1">
            <a:avLst/>
          </a:prstGeom>
          <a:ln>
            <a:headEnd w="sm" len="sm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78CA07CC-A3A3-447D-AE93-FF41A61428A2}"/>
              </a:ext>
            </a:extLst>
          </p:cNvPr>
          <p:cNvSpPr txBox="1"/>
          <p:nvPr/>
        </p:nvSpPr>
        <p:spPr>
          <a:xfrm>
            <a:off x="8323868" y="650449"/>
            <a:ext cx="1689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S1 annotation</a:t>
            </a:r>
          </a:p>
        </p:txBody>
      </p:sp>
    </p:spTree>
    <p:extLst>
      <p:ext uri="{BB962C8B-B14F-4D97-AF65-F5344CB8AC3E}">
        <p14:creationId xmlns:p14="http://schemas.microsoft.com/office/powerpoint/2010/main" val="1701415593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600" y="0"/>
            <a:ext cx="10972798" cy="68579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7146120" y="182590"/>
            <a:ext cx="34801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55170791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4C12784-F2E5-4794-9A5D-6B256C449F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5" y="140981"/>
            <a:ext cx="12192000" cy="60896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6977499" y="539592"/>
            <a:ext cx="5086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08601DE-CDDC-4DB9-85DF-84DC77419C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53674" y="1857853"/>
            <a:ext cx="2932112" cy="774520"/>
          </a:xfrm>
          <a:prstGeom prst="rect">
            <a:avLst/>
          </a:prstGeom>
          <a:solidFill>
            <a:schemeClr val="bg1"/>
          </a:solidFill>
          <a:ln>
            <a:solidFill>
              <a:schemeClr val="dk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08F506D-5655-49A6-88E6-4B31099E69D9}"/>
              </a:ext>
            </a:extLst>
          </p:cNvPr>
          <p:cNvSpPr txBox="1"/>
          <p:nvPr/>
        </p:nvSpPr>
        <p:spPr>
          <a:xfrm>
            <a:off x="2417386" y="1872457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4 /2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C164FE7-703B-456F-838D-FD041613751D}"/>
              </a:ext>
            </a:extLst>
          </p:cNvPr>
          <p:cNvSpPr txBox="1"/>
          <p:nvPr/>
        </p:nvSpPr>
        <p:spPr>
          <a:xfrm>
            <a:off x="3394400" y="1872456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5 /2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7F5E5AD-C55E-4641-905A-4B096BBBF8AD}"/>
              </a:ext>
            </a:extLst>
          </p:cNvPr>
          <p:cNvSpPr txBox="1"/>
          <p:nvPr/>
        </p:nvSpPr>
        <p:spPr>
          <a:xfrm>
            <a:off x="4513447" y="1869480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6 /2+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09A3CF0-2443-4684-B982-5F01DE87CC1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79121" y="3253124"/>
            <a:ext cx="3229151" cy="853440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484AD261-7738-40FD-90A1-8E1D21D804FE}"/>
              </a:ext>
            </a:extLst>
          </p:cNvPr>
          <p:cNvSpPr txBox="1"/>
          <p:nvPr/>
        </p:nvSpPr>
        <p:spPr>
          <a:xfrm>
            <a:off x="5133184" y="3249033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8 /2+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7DDD6A-F802-4495-B36F-132CB762F88C}"/>
              </a:ext>
            </a:extLst>
          </p:cNvPr>
          <p:cNvSpPr txBox="1"/>
          <p:nvPr/>
        </p:nvSpPr>
        <p:spPr>
          <a:xfrm>
            <a:off x="2555848" y="3244497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7 /2+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168224F-EDDA-4D1F-9F85-DF1B4A6E448C}"/>
              </a:ext>
            </a:extLst>
          </p:cNvPr>
          <p:cNvSpPr/>
          <p:nvPr/>
        </p:nvSpPr>
        <p:spPr>
          <a:xfrm>
            <a:off x="5760566" y="1829937"/>
            <a:ext cx="719749" cy="107558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4E4BF3D2-CD5A-4ECB-8B9A-070CF381E82D}"/>
              </a:ext>
            </a:extLst>
          </p:cNvPr>
          <p:cNvCxnSpPr>
            <a:cxnSpLocks/>
            <a:stCxn id="24" idx="1"/>
            <a:endCxn id="9" idx="3"/>
          </p:cNvCxnSpPr>
          <p:nvPr/>
        </p:nvCxnSpPr>
        <p:spPr>
          <a:xfrm flipH="1" flipV="1">
            <a:off x="5285786" y="2245113"/>
            <a:ext cx="474780" cy="1226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Rectangle 27">
            <a:extLst>
              <a:ext uri="{FF2B5EF4-FFF2-40B4-BE49-F238E27FC236}">
                <a16:creationId xmlns:a16="http://schemas.microsoft.com/office/drawing/2014/main" id="{040B3EB3-7128-4ED7-AE4D-3D2AB7B63E06}"/>
              </a:ext>
            </a:extLst>
          </p:cNvPr>
          <p:cNvSpPr/>
          <p:nvPr/>
        </p:nvSpPr>
        <p:spPr>
          <a:xfrm>
            <a:off x="6557022" y="4495783"/>
            <a:ext cx="360613" cy="70104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EA3E73B6-009B-443B-A888-22AAC911B178}"/>
              </a:ext>
            </a:extLst>
          </p:cNvPr>
          <p:cNvCxnSpPr>
            <a:cxnSpLocks/>
            <a:stCxn id="28" idx="1"/>
            <a:endCxn id="11" idx="2"/>
          </p:cNvCxnSpPr>
          <p:nvPr/>
        </p:nvCxnSpPr>
        <p:spPr>
          <a:xfrm flipH="1" flipV="1">
            <a:off x="4193697" y="4106564"/>
            <a:ext cx="2363325" cy="73974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6527FBD-224C-4525-8C75-1D362589F9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6622112"/>
              </p:ext>
            </p:extLst>
          </p:nvPr>
        </p:nvGraphicFramePr>
        <p:xfrm>
          <a:off x="378322" y="6305522"/>
          <a:ext cx="7315200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129163834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8936665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14463860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21686473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11219240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83092650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66744678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00476348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25160217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46721849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24768136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11607171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ragmen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2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3 1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4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5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6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7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8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11 2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12 2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9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z13+H 2+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16706381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/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56.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7.1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1221.995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1278.523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322.027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1386.55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430.079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374.4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409.9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2513.961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2476.4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2203133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3715441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3123306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5ACE6-F03D-4CA8-AE60-DE06C72BD0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/>
              <a:t>3. Spectrum annotation examples of O-glycopeptides in human serum data (Fig. 3e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4853107"/>
            <a:ext cx="10515600" cy="1850083"/>
          </a:xfrm>
        </p:spPr>
        <p:txBody>
          <a:bodyPr>
            <a:normAutofit/>
          </a:bodyPr>
          <a:lstStyle/>
          <a:p>
            <a:r>
              <a:rPr lang="en-US" sz="2000" dirty="0"/>
              <a:t>RAW: 1-1.raw, 1-2.raw, 1-3.raw</a:t>
            </a:r>
          </a:p>
          <a:p>
            <a:r>
              <a:rPr lang="en-US" sz="2000" dirty="0"/>
              <a:t>Glycopeptide FDR (“</a:t>
            </a:r>
            <a:r>
              <a:rPr lang="en-US" sz="2000" dirty="0" err="1"/>
              <a:t>TotalFDR</a:t>
            </a:r>
            <a:r>
              <a:rPr lang="en-US" sz="2000" dirty="0"/>
              <a:t>”) &lt;= 0.01</a:t>
            </a:r>
          </a:p>
          <a:p>
            <a:r>
              <a:rPr lang="en-US" sz="2000" dirty="0"/>
              <a:t>SSGL format: </a:t>
            </a:r>
            <a:r>
              <a:rPr lang="en-US" sz="2000" dirty="0" err="1"/>
              <a:t>Site-Glycan@Prob</a:t>
            </a:r>
            <a:r>
              <a:rPr lang="en-US" sz="2000" dirty="0"/>
              <a:t>, </a:t>
            </a:r>
            <a:r>
              <a:rPr lang="en-US" sz="2000" dirty="0" err="1"/>
              <a:t>Site-Glycan@Prob</a:t>
            </a:r>
            <a:r>
              <a:rPr lang="en-US" sz="2000" dirty="0"/>
              <a:t>, …</a:t>
            </a:r>
          </a:p>
          <a:p>
            <a:pPr lvl="1"/>
            <a:r>
              <a:rPr lang="en-US" sz="1800" dirty="0"/>
              <a:t>SSGL with Prob &gt; 0.75 were displayed in Fig. 3e; site-groups were removed</a:t>
            </a:r>
          </a:p>
          <a:p>
            <a:pPr lvl="1"/>
            <a:r>
              <a:rPr lang="en-US" sz="1800" dirty="0"/>
              <a:t>Zoom-in regions of key c/z ions for SSGL were displayed in each EThcD spectrum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5BC5EC2-9364-4F64-81C0-C68553D00C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21672" y="1608215"/>
            <a:ext cx="5835954" cy="37777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11660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>
            <a:normAutofit lnSpcReduction="10000"/>
          </a:bodyPr>
          <a:lstStyle/>
          <a:p>
            <a:r>
              <a:rPr lang="en-US" sz="2400" dirty="0"/>
              <a:t>Spectrum 1 (Fig. 3f)</a:t>
            </a:r>
          </a:p>
          <a:p>
            <a:endParaRPr lang="en-US" sz="2400" dirty="0"/>
          </a:p>
          <a:p>
            <a:r>
              <a:rPr lang="en-US" sz="2400" dirty="0"/>
              <a:t>RAW=1-1, HCD Scan=14308, EThcD Scan=14309</a:t>
            </a:r>
          </a:p>
          <a:p>
            <a:endParaRPr lang="en-US" sz="2400" dirty="0"/>
          </a:p>
          <a:p>
            <a:r>
              <a:rPr lang="en-US" sz="2400" dirty="0"/>
              <a:t>Peptide: IGEIKEETTVSPPHTSMAPAQDEER, protein: KNG1</a:t>
            </a:r>
          </a:p>
          <a:p>
            <a:endParaRPr lang="en-US" sz="2400" dirty="0"/>
          </a:p>
          <a:p>
            <a:r>
              <a:rPr lang="en-US" sz="2400" dirty="0"/>
              <a:t>SSGL: T9-H(1)N(1)A(1)@92%, S11-H(1)N(1)A(1)@92%, T15~S16-H(1)N(1)A(1)@87%</a:t>
            </a:r>
          </a:p>
          <a:p>
            <a:pPr lvl="1"/>
            <a:endParaRPr lang="en-US" sz="1600" dirty="0"/>
          </a:p>
          <a:p>
            <a:r>
              <a:rPr lang="en-US" sz="2400" dirty="0"/>
              <a:t>SSGL on protein (not including site-groups)</a:t>
            </a:r>
          </a:p>
          <a:p>
            <a:pPr lvl="1"/>
            <a:r>
              <a:rPr lang="en-US" sz="2000" dirty="0"/>
              <a:t>T401-H(1)N(1)A(1), S403-H(1)N(1)A(1)</a:t>
            </a:r>
          </a:p>
          <a:p>
            <a:endParaRPr lang="en-US" sz="2400" dirty="0"/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3789623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600" y="0"/>
            <a:ext cx="10972798" cy="685799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7957006" y="208469"/>
            <a:ext cx="348018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3719814109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31D64D9-7B3A-4D48-B6FA-AB899F9960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31256"/>
            <a:ext cx="12192000" cy="60896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8816196" y="365965"/>
            <a:ext cx="28294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B5B8AF8-C3F4-4F9A-B66A-A761D145C382}"/>
              </a:ext>
            </a:extLst>
          </p:cNvPr>
          <p:cNvSpPr txBox="1"/>
          <p:nvPr/>
        </p:nvSpPr>
        <p:spPr>
          <a:xfrm>
            <a:off x="6096000" y="210865"/>
            <a:ext cx="9208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(Fig. 3f)</a:t>
            </a:r>
          </a:p>
        </p:txBody>
      </p:sp>
      <p:graphicFrame>
        <p:nvGraphicFramePr>
          <p:cNvPr id="52" name="Table 51">
            <a:extLst>
              <a:ext uri="{FF2B5EF4-FFF2-40B4-BE49-F238E27FC236}">
                <a16:creationId xmlns:a16="http://schemas.microsoft.com/office/drawing/2014/main" id="{70C7842B-18F6-4D94-A005-ED9E22A9D6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5058297"/>
              </p:ext>
            </p:extLst>
          </p:nvPr>
        </p:nvGraphicFramePr>
        <p:xfrm>
          <a:off x="68095" y="6318455"/>
          <a:ext cx="11994201" cy="31623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96141">
                  <a:extLst>
                    <a:ext uri="{9D8B030D-6E8A-4147-A177-3AD203B41FA5}">
                      <a16:colId xmlns:a16="http://schemas.microsoft.com/office/drawing/2014/main" val="1154154664"/>
                    </a:ext>
                  </a:extLst>
                </a:gridCol>
                <a:gridCol w="446833">
                  <a:extLst>
                    <a:ext uri="{9D8B030D-6E8A-4147-A177-3AD203B41FA5}">
                      <a16:colId xmlns:a16="http://schemas.microsoft.com/office/drawing/2014/main" val="4154305176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3997947400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1523603578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1428039745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4171866532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1676730955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905610313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1493284700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2272458128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3710331908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2394783701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3938303532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2773655051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1321339410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1553955814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2788680506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1807735864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3787750570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1466398320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2523999903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347511617"/>
                    </a:ext>
                  </a:extLst>
                </a:gridCol>
                <a:gridCol w="521487">
                  <a:extLst>
                    <a:ext uri="{9D8B030D-6E8A-4147-A177-3AD203B41FA5}">
                      <a16:colId xmlns:a16="http://schemas.microsoft.com/office/drawing/2014/main" val="2324617121"/>
                    </a:ext>
                  </a:extLst>
                </a:gridCol>
              </a:tblGrid>
              <a:tr h="13716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Fragmen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4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5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6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7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8 1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9 1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12 2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14 2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16 2+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17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9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8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6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5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4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3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2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8+H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16+H 2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15+H 2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12+H 2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extLst>
                  <a:ext uri="{0D108BD9-81ED-4DB2-BD59-A6C34878D82A}">
                    <a16:rowId xmlns:a16="http://schemas.microsoft.com/office/drawing/2014/main" val="1010752451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/z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430.26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58.3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87.4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16.4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917.498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674.751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307.573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424.616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1846.78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912.27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030.4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99.4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31.3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60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32.2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17.1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88.1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59.1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954.2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525.109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475.62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006.911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15" marR="5715" marT="5715" marB="0" anchor="b"/>
                </a:tc>
                <a:extLst>
                  <a:ext uri="{0D108BD9-81ED-4DB2-BD59-A6C34878D82A}">
                    <a16:rowId xmlns:a16="http://schemas.microsoft.com/office/drawing/2014/main" val="39352775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73807489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31D64D9-7B3A-4D48-B6FA-AB899F9960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84175"/>
            <a:ext cx="12192000" cy="60896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8816196" y="618884"/>
            <a:ext cx="28294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168224F-EDDA-4D1F-9F85-DF1B4A6E448C}"/>
              </a:ext>
            </a:extLst>
          </p:cNvPr>
          <p:cNvSpPr/>
          <p:nvPr/>
        </p:nvSpPr>
        <p:spPr>
          <a:xfrm>
            <a:off x="5523176" y="5032266"/>
            <a:ext cx="334160" cy="41603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4E4BF3D2-CD5A-4ECB-8B9A-070CF381E82D}"/>
              </a:ext>
            </a:extLst>
          </p:cNvPr>
          <p:cNvCxnSpPr>
            <a:cxnSpLocks/>
            <a:stCxn id="24" idx="1"/>
            <a:endCxn id="8" idx="2"/>
          </p:cNvCxnSpPr>
          <p:nvPr/>
        </p:nvCxnSpPr>
        <p:spPr>
          <a:xfrm flipH="1" flipV="1">
            <a:off x="3265652" y="4681306"/>
            <a:ext cx="2257524" cy="5589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7B5B8AF8-C3F4-4F9A-B66A-A761D145C382}"/>
              </a:ext>
            </a:extLst>
          </p:cNvPr>
          <p:cNvSpPr txBox="1"/>
          <p:nvPr/>
        </p:nvSpPr>
        <p:spPr>
          <a:xfrm>
            <a:off x="6096000" y="463784"/>
            <a:ext cx="9208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(Fig. 3f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6FF4948-23E6-41F1-95CC-E1A8076112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8127" y="2712719"/>
            <a:ext cx="4515049" cy="19685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E1ED7D9-794F-4EE4-853A-AE39424AA764}"/>
              </a:ext>
            </a:extLst>
          </p:cNvPr>
          <p:cNvSpPr txBox="1"/>
          <p:nvPr/>
        </p:nvSpPr>
        <p:spPr>
          <a:xfrm>
            <a:off x="4252416" y="2888786"/>
            <a:ext cx="13227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8 /1+, </a:t>
            </a:r>
            <a:r>
              <a:rPr lang="en-US" sz="14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917.498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AE21D875-A86F-4EBA-ADE9-765318DAFA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58849" y="2712719"/>
            <a:ext cx="5042347" cy="1968587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39F7AAA1-0816-4B32-BC07-F6F758C5D55B}"/>
              </a:ext>
            </a:extLst>
          </p:cNvPr>
          <p:cNvSpPr/>
          <p:nvPr/>
        </p:nvSpPr>
        <p:spPr>
          <a:xfrm>
            <a:off x="9766515" y="5024919"/>
            <a:ext cx="334160" cy="41603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1E72CF5B-A828-4ADE-A207-8A24F53B2615}"/>
              </a:ext>
            </a:extLst>
          </p:cNvPr>
          <p:cNvCxnSpPr>
            <a:cxnSpLocks/>
            <a:stCxn id="32" idx="0"/>
            <a:endCxn id="29" idx="2"/>
          </p:cNvCxnSpPr>
          <p:nvPr/>
        </p:nvCxnSpPr>
        <p:spPr>
          <a:xfrm flipH="1" flipV="1">
            <a:off x="8680023" y="4681306"/>
            <a:ext cx="1253572" cy="3436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AE701F46-7D2D-4FE2-9331-AB50169FD50D}"/>
              </a:ext>
            </a:extLst>
          </p:cNvPr>
          <p:cNvSpPr txBox="1"/>
          <p:nvPr/>
        </p:nvSpPr>
        <p:spPr>
          <a:xfrm>
            <a:off x="9772156" y="2837041"/>
            <a:ext cx="14141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9 /1+, </a:t>
            </a:r>
            <a:r>
              <a:rPr lang="en-US" sz="14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674.751</a:t>
            </a:r>
          </a:p>
        </p:txBody>
      </p:sp>
    </p:spTree>
    <p:extLst>
      <p:ext uri="{BB962C8B-B14F-4D97-AF65-F5344CB8AC3E}">
        <p14:creationId xmlns:p14="http://schemas.microsoft.com/office/powerpoint/2010/main" val="2748530008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31D64D9-7B3A-4D48-B6FA-AB899F9960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84175"/>
            <a:ext cx="12192000" cy="60896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8816196" y="618884"/>
            <a:ext cx="28294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B5B8AF8-C3F4-4F9A-B66A-A761D145C382}"/>
              </a:ext>
            </a:extLst>
          </p:cNvPr>
          <p:cNvSpPr txBox="1"/>
          <p:nvPr/>
        </p:nvSpPr>
        <p:spPr>
          <a:xfrm>
            <a:off x="6096000" y="463784"/>
            <a:ext cx="9208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(Fig. 3f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0EC3E78-04BB-45BB-BFE1-9218E7E25D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94163" y="3230549"/>
            <a:ext cx="4521711" cy="17030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F76F6506-F3B5-4C90-9D9A-7C0388878449}"/>
              </a:ext>
            </a:extLst>
          </p:cNvPr>
          <p:cNvSpPr/>
          <p:nvPr/>
        </p:nvSpPr>
        <p:spPr>
          <a:xfrm>
            <a:off x="7843519" y="5086350"/>
            <a:ext cx="147955" cy="34036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A237F697-B8F7-403E-8862-DE42532E3492}"/>
              </a:ext>
            </a:extLst>
          </p:cNvPr>
          <p:cNvCxnSpPr>
            <a:cxnSpLocks/>
            <a:stCxn id="12" idx="1"/>
            <a:endCxn id="8" idx="2"/>
          </p:cNvCxnSpPr>
          <p:nvPr/>
        </p:nvCxnSpPr>
        <p:spPr>
          <a:xfrm flipH="1" flipV="1">
            <a:off x="5855019" y="4933641"/>
            <a:ext cx="1988500" cy="32288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656BBC42-62E2-4C39-8E1A-64A2D1B43665}"/>
              </a:ext>
            </a:extLst>
          </p:cNvPr>
          <p:cNvSpPr txBox="1"/>
          <p:nvPr/>
        </p:nvSpPr>
        <p:spPr>
          <a:xfrm>
            <a:off x="6762033" y="3419477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12 /2+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04BCDEB4-1BC4-496C-A434-812C616F812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07788" y="3335324"/>
            <a:ext cx="2829465" cy="17030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774AA583-9E34-4720-BAFD-3867FE49A578}"/>
              </a:ext>
            </a:extLst>
          </p:cNvPr>
          <p:cNvSpPr/>
          <p:nvPr/>
        </p:nvSpPr>
        <p:spPr>
          <a:xfrm>
            <a:off x="8519794" y="5086350"/>
            <a:ext cx="147955" cy="34036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6AA8FC40-B9DA-4692-98A5-789FF1DC7D41}"/>
              </a:ext>
            </a:extLst>
          </p:cNvPr>
          <p:cNvCxnSpPr>
            <a:cxnSpLocks/>
            <a:stCxn id="21" idx="3"/>
            <a:endCxn id="17" idx="2"/>
          </p:cNvCxnSpPr>
          <p:nvPr/>
        </p:nvCxnSpPr>
        <p:spPr>
          <a:xfrm flipV="1">
            <a:off x="8667749" y="5038416"/>
            <a:ext cx="954772" cy="2181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6FC7DEBF-35D9-4862-9B56-49D7B2756DCD}"/>
              </a:ext>
            </a:extLst>
          </p:cNvPr>
          <p:cNvSpPr txBox="1"/>
          <p:nvPr/>
        </p:nvSpPr>
        <p:spPr>
          <a:xfrm>
            <a:off x="8703635" y="3329754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14 /2+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3F2A110F-4E05-4BEC-8436-7E0509716D4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90327" y="3293684"/>
            <a:ext cx="1781147" cy="1221165"/>
          </a:xfrm>
          <a:prstGeom prst="rect">
            <a:avLst/>
          </a:prstGeom>
        </p:spPr>
      </p:pic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E7674B98-EA89-41EF-987A-7049A68168B3}"/>
              </a:ext>
            </a:extLst>
          </p:cNvPr>
          <p:cNvCxnSpPr>
            <a:cxnSpLocks/>
          </p:cNvCxnSpPr>
          <p:nvPr/>
        </p:nvCxnSpPr>
        <p:spPr>
          <a:xfrm flipH="1" flipV="1">
            <a:off x="6086475" y="3552825"/>
            <a:ext cx="1104901" cy="8286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8" name="Picture 37">
            <a:extLst>
              <a:ext uri="{FF2B5EF4-FFF2-40B4-BE49-F238E27FC236}">
                <a16:creationId xmlns:a16="http://schemas.microsoft.com/office/drawing/2014/main" id="{B3C4CD33-64B3-4B90-BDE9-B6715BC4A3A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07788" y="1339374"/>
            <a:ext cx="3223414" cy="1990380"/>
          </a:xfrm>
          <a:prstGeom prst="rect">
            <a:avLst/>
          </a:prstGeom>
        </p:spPr>
      </p:pic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AB4B86E4-E12A-4898-AABD-46DDA50EE66D}"/>
              </a:ext>
            </a:extLst>
          </p:cNvPr>
          <p:cNvCxnSpPr>
            <a:cxnSpLocks/>
          </p:cNvCxnSpPr>
          <p:nvPr/>
        </p:nvCxnSpPr>
        <p:spPr>
          <a:xfrm flipV="1">
            <a:off x="9214472" y="1499925"/>
            <a:ext cx="1656342" cy="25386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970814FA-6D7E-4D96-91C6-00F3F3955116}"/>
              </a:ext>
            </a:extLst>
          </p:cNvPr>
          <p:cNvSpPr txBox="1"/>
          <p:nvPr/>
        </p:nvSpPr>
        <p:spPr>
          <a:xfrm rot="18239511">
            <a:off x="8889483" y="3752501"/>
            <a:ext cx="13997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Interfered with other ions</a:t>
            </a:r>
          </a:p>
        </p:txBody>
      </p:sp>
    </p:spTree>
    <p:extLst>
      <p:ext uri="{BB962C8B-B14F-4D97-AF65-F5344CB8AC3E}">
        <p14:creationId xmlns:p14="http://schemas.microsoft.com/office/powerpoint/2010/main" val="2648068362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31D64D9-7B3A-4D48-B6FA-AB899F9960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84175"/>
            <a:ext cx="12192000" cy="60896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8816196" y="618884"/>
            <a:ext cx="28294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B5B8AF8-C3F4-4F9A-B66A-A761D145C382}"/>
              </a:ext>
            </a:extLst>
          </p:cNvPr>
          <p:cNvSpPr txBox="1"/>
          <p:nvPr/>
        </p:nvSpPr>
        <p:spPr>
          <a:xfrm>
            <a:off x="6096000" y="463784"/>
            <a:ext cx="9208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(Fig. 3f)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BEC348DA-0438-4AEC-BADA-6E36CD266237}"/>
              </a:ext>
            </a:extLst>
          </p:cNvPr>
          <p:cNvSpPr/>
          <p:nvPr/>
        </p:nvSpPr>
        <p:spPr>
          <a:xfrm>
            <a:off x="8719819" y="4638903"/>
            <a:ext cx="580881" cy="81638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8B356D79-0F7E-450D-A095-6B1835E85211}"/>
              </a:ext>
            </a:extLst>
          </p:cNvPr>
          <p:cNvCxnSpPr>
            <a:cxnSpLocks/>
            <a:stCxn id="38" idx="1"/>
            <a:endCxn id="44" idx="2"/>
          </p:cNvCxnSpPr>
          <p:nvPr/>
        </p:nvCxnSpPr>
        <p:spPr>
          <a:xfrm flipH="1" flipV="1">
            <a:off x="5602611" y="4611153"/>
            <a:ext cx="3117208" cy="4359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4" name="Picture 43">
            <a:extLst>
              <a:ext uri="{FF2B5EF4-FFF2-40B4-BE49-F238E27FC236}">
                <a16:creationId xmlns:a16="http://schemas.microsoft.com/office/drawing/2014/main" id="{3DAAF2AB-F906-453B-B31F-D66381DF24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1220" y="2111230"/>
            <a:ext cx="6082782" cy="2499923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0EEC6DDB-6C37-4D9A-94EF-703F455F5559}"/>
              </a:ext>
            </a:extLst>
          </p:cNvPr>
          <p:cNvSpPr txBox="1"/>
          <p:nvPr/>
        </p:nvSpPr>
        <p:spPr>
          <a:xfrm rot="16200000">
            <a:off x="2948322" y="2877197"/>
            <a:ext cx="1608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z15+H /2+, </a:t>
            </a:r>
            <a:r>
              <a:rPr lang="en-US" sz="14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475.6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722F201-2D0D-4C0B-A973-C4B2DC3EA9D1}"/>
              </a:ext>
            </a:extLst>
          </p:cNvPr>
          <p:cNvSpPr txBox="1"/>
          <p:nvPr/>
        </p:nvSpPr>
        <p:spPr>
          <a:xfrm rot="16200000">
            <a:off x="7315805" y="2953211"/>
            <a:ext cx="19159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z16+H /2+, </a:t>
            </a:r>
            <a:r>
              <a:rPr lang="en-US" sz="16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525.109</a:t>
            </a:r>
            <a:endParaRPr lang="en-US" sz="16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3347FB3-5905-40CA-A370-EB54016F129F}"/>
              </a:ext>
            </a:extLst>
          </p:cNvPr>
          <p:cNvSpPr txBox="1"/>
          <p:nvPr/>
        </p:nvSpPr>
        <p:spPr>
          <a:xfrm>
            <a:off x="5241074" y="3097079"/>
            <a:ext cx="27451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z16? The mass error is 21 ppm (matching tolerance is 20 ppm)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CCA7D495-852B-48B0-8134-019336D4FE65}"/>
              </a:ext>
            </a:extLst>
          </p:cNvPr>
          <p:cNvCxnSpPr>
            <a:cxnSpLocks/>
            <a:endCxn id="34" idx="2"/>
          </p:cNvCxnSpPr>
          <p:nvPr/>
        </p:nvCxnSpPr>
        <p:spPr>
          <a:xfrm flipH="1" flipV="1">
            <a:off x="6613639" y="3681854"/>
            <a:ext cx="1673332" cy="6448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9503098F-546C-4F87-ACDE-0E5484D4F8F9}"/>
              </a:ext>
            </a:extLst>
          </p:cNvPr>
          <p:cNvSpPr txBox="1"/>
          <p:nvPr/>
        </p:nvSpPr>
        <p:spPr>
          <a:xfrm>
            <a:off x="2594930" y="2529195"/>
            <a:ext cx="133898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t z15, the mass error is &gt;70 ppm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CBECD45D-ECC8-4B85-86B1-915079231BD6}"/>
              </a:ext>
            </a:extLst>
          </p:cNvPr>
          <p:cNvCxnSpPr>
            <a:cxnSpLocks/>
            <a:endCxn id="45" idx="2"/>
          </p:cNvCxnSpPr>
          <p:nvPr/>
        </p:nvCxnSpPr>
        <p:spPr>
          <a:xfrm flipH="1" flipV="1">
            <a:off x="3264422" y="3267859"/>
            <a:ext cx="497953" cy="9232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829310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29463D9-6E23-482A-BA1A-DD2436BAE9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196" y="163286"/>
            <a:ext cx="7919150" cy="326571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14929D9-04F1-4498-BCE2-03A8AA9AD6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V="1">
            <a:off x="90194" y="3425031"/>
            <a:ext cx="7919150" cy="267713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D6A9F96-8957-43F8-96EA-C00EF2A33F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194" y="6101124"/>
            <a:ext cx="7919150" cy="67795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2FF0E47-72DA-4CDF-B7BA-85DF699EE7AA}"/>
              </a:ext>
            </a:extLst>
          </p:cNvPr>
          <p:cNvSpPr txBox="1"/>
          <p:nvPr/>
        </p:nvSpPr>
        <p:spPr>
          <a:xfrm>
            <a:off x="3597150" y="6286731"/>
            <a:ext cx="1075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N-labeled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E7B4B15E-8CC7-4AE8-8B65-1EEE2E1868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5365269"/>
              </p:ext>
            </p:extLst>
          </p:nvPr>
        </p:nvGraphicFramePr>
        <p:xfrm>
          <a:off x="8338362" y="369125"/>
          <a:ext cx="3325230" cy="6409952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1286054">
                  <a:extLst>
                    <a:ext uri="{9D8B030D-6E8A-4147-A177-3AD203B41FA5}">
                      <a16:colId xmlns:a16="http://schemas.microsoft.com/office/drawing/2014/main" val="2495189960"/>
                    </a:ext>
                  </a:extLst>
                </a:gridCol>
                <a:gridCol w="1019588">
                  <a:extLst>
                    <a:ext uri="{9D8B030D-6E8A-4147-A177-3AD203B41FA5}">
                      <a16:colId xmlns:a16="http://schemas.microsoft.com/office/drawing/2014/main" val="4140547952"/>
                    </a:ext>
                  </a:extLst>
                </a:gridCol>
                <a:gridCol w="1019588">
                  <a:extLst>
                    <a:ext uri="{9D8B030D-6E8A-4147-A177-3AD203B41FA5}">
                      <a16:colId xmlns:a16="http://schemas.microsoft.com/office/drawing/2014/main" val="939405415"/>
                    </a:ext>
                  </a:extLst>
                </a:gridCol>
              </a:tblGrid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Fragment typ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38" marR="7138" marT="713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/z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38" marR="7138" marT="713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15N-m/z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38" marR="7138" marT="7138" marB="0" anchor="b"/>
                </a:tc>
                <a:extLst>
                  <a:ext uri="{0D108BD9-81ED-4DB2-BD59-A6C34878D82A}">
                    <a16:rowId xmlns:a16="http://schemas.microsoft.com/office/drawing/2014/main" val="2722843352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0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9.54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5.505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455189368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0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0.27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8.25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166113076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1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4.38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3.351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16785371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1)N(2) 3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3.25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9.236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86941001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2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5.40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4.38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59006003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2)N(2) 3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7.27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3.26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8424775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3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6.43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5.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465447125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3)N(2) 3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1.29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7.275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91977416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4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7.46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6.442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596969123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5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8.49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7.45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15753245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6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9.514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8.492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72324011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8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1.56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0.541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60536416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9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2.5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1.59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968169382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1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2.62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9.57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940147933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1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1.81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0.292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667011733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2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25.70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43.65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91178608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3.35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2.331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290980655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2) 3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9.24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5.22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6896394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2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8.13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1.12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948916745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3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9.16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3.15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810018625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5-N(1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3.33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1.29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30132152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6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6.32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5.309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065538938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1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5.11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.10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32532010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2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6.16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1.15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276819420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3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3.18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9.1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16308878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4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4.23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1.21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487894179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5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0.31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9.289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45313428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7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1.37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3.34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59017089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7-N(1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4.46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37.431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022132608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8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2.4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5.38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17827257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8-N(1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5.50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9.45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328400112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95D4054-D7AF-45BC-BC86-7C9D6354F581}"/>
              </a:ext>
            </a:extLst>
          </p:cNvPr>
          <p:cNvSpPr txBox="1"/>
          <p:nvPr/>
        </p:nvSpPr>
        <p:spPr>
          <a:xfrm>
            <a:off x="8486174" y="0"/>
            <a:ext cx="3050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tched same fragment type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5B43C1A5-98C2-4DD0-878E-43012810EB7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95588"/>
          <a:stretch/>
        </p:blipFill>
        <p:spPr>
          <a:xfrm>
            <a:off x="90194" y="3434593"/>
            <a:ext cx="7919150" cy="11812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6B1DD22-6659-45B6-8078-0301E0D88485}"/>
              </a:ext>
            </a:extLst>
          </p:cNvPr>
          <p:cNvSpPr txBox="1"/>
          <p:nvPr/>
        </p:nvSpPr>
        <p:spPr>
          <a:xfrm>
            <a:off x="4827913" y="6140450"/>
            <a:ext cx="29674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Fragment ions are complementary to each other</a:t>
            </a:r>
          </a:p>
        </p:txBody>
      </p:sp>
    </p:spTree>
    <p:extLst>
      <p:ext uri="{BB962C8B-B14F-4D97-AF65-F5344CB8AC3E}">
        <p14:creationId xmlns:p14="http://schemas.microsoft.com/office/powerpoint/2010/main" val="3735571332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31D64D9-7B3A-4D48-B6FA-AB899F9960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84175"/>
            <a:ext cx="12192000" cy="60896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8816196" y="618884"/>
            <a:ext cx="28294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B5B8AF8-C3F4-4F9A-B66A-A761D145C382}"/>
              </a:ext>
            </a:extLst>
          </p:cNvPr>
          <p:cNvSpPr txBox="1"/>
          <p:nvPr/>
        </p:nvSpPr>
        <p:spPr>
          <a:xfrm>
            <a:off x="6096000" y="463784"/>
            <a:ext cx="9208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(Fig. 3f)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CD7637D4-1F36-4706-949C-23079CF41932}"/>
              </a:ext>
            </a:extLst>
          </p:cNvPr>
          <p:cNvCxnSpPr>
            <a:cxnSpLocks/>
            <a:stCxn id="10" idx="1"/>
            <a:endCxn id="9" idx="2"/>
          </p:cNvCxnSpPr>
          <p:nvPr/>
        </p:nvCxnSpPr>
        <p:spPr>
          <a:xfrm flipH="1" flipV="1">
            <a:off x="3445817" y="4411181"/>
            <a:ext cx="2718764" cy="84534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A52FB8F0-B3BF-4DAF-99C8-53BE1C8AA9F6}"/>
              </a:ext>
            </a:extLst>
          </p:cNvPr>
          <p:cNvSpPr/>
          <p:nvPr/>
        </p:nvSpPr>
        <p:spPr>
          <a:xfrm>
            <a:off x="6164581" y="5086350"/>
            <a:ext cx="182880" cy="34036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71C3FDC-502F-4F0F-8656-BFBBCDD23A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5333" y="2111600"/>
            <a:ext cx="5380967" cy="2299581"/>
          </a:xfrm>
          <a:prstGeom prst="rect">
            <a:avLst/>
          </a:prstGeom>
          <a:solidFill>
            <a:schemeClr val="bg1"/>
          </a:solidFill>
          <a:ln>
            <a:solidFill>
              <a:schemeClr val="dk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7AF9E4D-2425-4A63-A2D8-BC2F51AABEDE}"/>
              </a:ext>
            </a:extLst>
          </p:cNvPr>
          <p:cNvSpPr txBox="1"/>
          <p:nvPr/>
        </p:nvSpPr>
        <p:spPr>
          <a:xfrm>
            <a:off x="3088978" y="2542960"/>
            <a:ext cx="2135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z12+H /2+, </a:t>
            </a:r>
            <a:r>
              <a:rPr lang="en-US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006.911</a:t>
            </a:r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FF41965-23F2-43B1-9724-D3FC4D8BBFE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27152" y="1948037"/>
            <a:ext cx="3455370" cy="29787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005BCE07-C47C-4643-ABFC-B5CEC55DD697}"/>
              </a:ext>
            </a:extLst>
          </p:cNvPr>
          <p:cNvSpPr/>
          <p:nvPr/>
        </p:nvSpPr>
        <p:spPr>
          <a:xfrm>
            <a:off x="10804140" y="5086350"/>
            <a:ext cx="611720" cy="34036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A30E79F-1E87-4B4A-BE8C-1792BF5FD175}"/>
              </a:ext>
            </a:extLst>
          </p:cNvPr>
          <p:cNvCxnSpPr>
            <a:cxnSpLocks/>
            <a:stCxn id="15" idx="1"/>
            <a:endCxn id="11" idx="2"/>
          </p:cNvCxnSpPr>
          <p:nvPr/>
        </p:nvCxnSpPr>
        <p:spPr>
          <a:xfrm flipH="1" flipV="1">
            <a:off x="8954837" y="4926804"/>
            <a:ext cx="1849303" cy="3297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F24DB18B-6FB9-4A62-B9D5-40B00BC7004E}"/>
              </a:ext>
            </a:extLst>
          </p:cNvPr>
          <p:cNvSpPr txBox="1"/>
          <p:nvPr/>
        </p:nvSpPr>
        <p:spPr>
          <a:xfrm rot="16200000">
            <a:off x="6604419" y="2880567"/>
            <a:ext cx="1821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16 /2+ 1846.781</a:t>
            </a:r>
          </a:p>
        </p:txBody>
      </p:sp>
    </p:spTree>
    <p:extLst>
      <p:ext uri="{BB962C8B-B14F-4D97-AF65-F5344CB8AC3E}">
        <p14:creationId xmlns:p14="http://schemas.microsoft.com/office/powerpoint/2010/main" val="99773295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>
            <a:normAutofit/>
          </a:bodyPr>
          <a:lstStyle/>
          <a:p>
            <a:r>
              <a:rPr lang="en-US" sz="2400" dirty="0"/>
              <a:t>Spectrum 2</a:t>
            </a:r>
          </a:p>
          <a:p>
            <a:endParaRPr lang="en-US" sz="2400" dirty="0"/>
          </a:p>
          <a:p>
            <a:r>
              <a:rPr lang="en-US" sz="2400" dirty="0"/>
              <a:t>RAW=1-3, HCD Scan=24105, EThcD Scan=24106</a:t>
            </a:r>
          </a:p>
          <a:p>
            <a:endParaRPr lang="en-US" sz="2400" dirty="0"/>
          </a:p>
          <a:p>
            <a:r>
              <a:rPr lang="en-US" sz="2400" dirty="0"/>
              <a:t>Peptide: IEETTMTTQTPAPIQAPSAILPLPGQSVER, protein: ITIH4</a:t>
            </a:r>
          </a:p>
          <a:p>
            <a:endParaRPr lang="en-US" sz="2400" dirty="0"/>
          </a:p>
          <a:p>
            <a:r>
              <a:rPr lang="en-US" sz="2400" dirty="0"/>
              <a:t>SSGL: T7-H(1)N(1)@88%, T8-H(1)N(1)A</a:t>
            </a:r>
            <a:r>
              <a:rPr lang="en-US" sz="2400"/>
              <a:t>(1)@90</a:t>
            </a:r>
            <a:r>
              <a:rPr lang="en-US" sz="2400" dirty="0"/>
              <a:t>%</a:t>
            </a:r>
          </a:p>
          <a:p>
            <a:pPr lvl="1"/>
            <a:endParaRPr lang="en-US" sz="2400" dirty="0"/>
          </a:p>
          <a:p>
            <a:r>
              <a:rPr lang="en-US" sz="2400" dirty="0"/>
              <a:t>SSGL on protein</a:t>
            </a:r>
          </a:p>
          <a:p>
            <a:pPr lvl="1"/>
            <a:r>
              <a:rPr lang="pt-BR" sz="2000" dirty="0"/>
              <a:t>T722-H(1)N(1), T723-H(1)N(1)A(1)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336077776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9933" y="0"/>
            <a:ext cx="10972797" cy="685799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8551736" y="235358"/>
            <a:ext cx="3350331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2479112329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26FD1FC-45FD-4CB7-A4BE-4C6B08CB33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85631"/>
            <a:ext cx="12192000" cy="60198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9013519" y="400600"/>
            <a:ext cx="282946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3DD82F62-6A9B-4407-B39E-2E991EBE58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0378533"/>
              </p:ext>
            </p:extLst>
          </p:nvPr>
        </p:nvGraphicFramePr>
        <p:xfrm>
          <a:off x="77824" y="6288955"/>
          <a:ext cx="12054192" cy="31575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44746">
                  <a:extLst>
                    <a:ext uri="{9D8B030D-6E8A-4147-A177-3AD203B41FA5}">
                      <a16:colId xmlns:a16="http://schemas.microsoft.com/office/drawing/2014/main" val="2899210014"/>
                    </a:ext>
                  </a:extLst>
                </a:gridCol>
                <a:gridCol w="459770">
                  <a:extLst>
                    <a:ext uri="{9D8B030D-6E8A-4147-A177-3AD203B41FA5}">
                      <a16:colId xmlns:a16="http://schemas.microsoft.com/office/drawing/2014/main" val="4227159778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3775299447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2958213752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1390581774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3333429249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3045977976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83788135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1625635495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3357170963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315784825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2278561898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2212330251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3526817674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3193730193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3824699290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1992120267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3294380187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2682189990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520530649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2079423667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4246540068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4046978426"/>
                    </a:ext>
                  </a:extLst>
                </a:gridCol>
                <a:gridCol w="502258">
                  <a:extLst>
                    <a:ext uri="{9D8B030D-6E8A-4147-A177-3AD203B41FA5}">
                      <a16:colId xmlns:a16="http://schemas.microsoft.com/office/drawing/2014/main" val="550232012"/>
                    </a:ext>
                  </a:extLst>
                </a:gridCol>
              </a:tblGrid>
              <a:tr h="1314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Fragmen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2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3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4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5 1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6 1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7 1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8 1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20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28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5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2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0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8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5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4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3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2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21 2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9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6+H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6+H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27+H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extLst>
                  <a:ext uri="{0D108BD9-81ED-4DB2-BD59-A6C34878D82A}">
                    <a16:rowId xmlns:a16="http://schemas.microsoft.com/office/drawing/2014/main" val="661076635"/>
                  </a:ext>
                </a:extLst>
              </a:tr>
              <a:tr h="1314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/z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60.1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89.2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90.2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solidFill>
                            <a:srgbClr val="C00000"/>
                          </a:solidFill>
                          <a:effectLst/>
                        </a:rPr>
                        <a:t>591.309</a:t>
                      </a:r>
                      <a:endParaRPr lang="en-US" sz="10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722.339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188.527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945.822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560.7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956.4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518.8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263.7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079.59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69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02.3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74.2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87.2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88.1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59.1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063.588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64.5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647.8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60.3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906.39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77" marR="5477" marT="5477" marB="0" anchor="b"/>
                </a:tc>
                <a:extLst>
                  <a:ext uri="{0D108BD9-81ED-4DB2-BD59-A6C34878D82A}">
                    <a16:rowId xmlns:a16="http://schemas.microsoft.com/office/drawing/2014/main" val="175426334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50253797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26FD1FC-45FD-4CB7-A4BE-4C6B08CB33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19100"/>
            <a:ext cx="12192000" cy="60198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7067471-1299-475D-95D0-41240A4007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7022" y="1758842"/>
            <a:ext cx="4883031" cy="334031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0C98C670-8AE2-4661-896A-49C1AE75811E}"/>
              </a:ext>
            </a:extLst>
          </p:cNvPr>
          <p:cNvSpPr/>
          <p:nvPr/>
        </p:nvSpPr>
        <p:spPr>
          <a:xfrm>
            <a:off x="3900792" y="4134255"/>
            <a:ext cx="894944" cy="130350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D795E23-CB97-465D-A45A-11FC5AF15DBE}"/>
              </a:ext>
            </a:extLst>
          </p:cNvPr>
          <p:cNvSpPr txBox="1"/>
          <p:nvPr/>
        </p:nvSpPr>
        <p:spPr>
          <a:xfrm rot="16200000">
            <a:off x="4578678" y="2906099"/>
            <a:ext cx="14847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5 /1+, </a:t>
            </a:r>
            <a:r>
              <a:rPr lang="en-US" sz="16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591.30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0953A4E-FF8D-4501-9E52-4EC4B750CADC}"/>
              </a:ext>
            </a:extLst>
          </p:cNvPr>
          <p:cNvSpPr txBox="1"/>
          <p:nvPr/>
        </p:nvSpPr>
        <p:spPr>
          <a:xfrm rot="16200000">
            <a:off x="8720317" y="2906098"/>
            <a:ext cx="14847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6 /1+, </a:t>
            </a:r>
            <a:r>
              <a:rPr lang="en-US" sz="16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722.339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8C5BDAD-ED08-4356-A112-8211244080DC}"/>
              </a:ext>
            </a:extLst>
          </p:cNvPr>
          <p:cNvCxnSpPr>
            <a:cxnSpLocks/>
            <a:stCxn id="7" idx="3"/>
            <a:endCxn id="6" idx="1"/>
          </p:cNvCxnSpPr>
          <p:nvPr/>
        </p:nvCxnSpPr>
        <p:spPr>
          <a:xfrm flipV="1">
            <a:off x="4795736" y="3429000"/>
            <a:ext cx="311286" cy="13570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CABE0C96-5678-41F7-8E0B-0A4FF07F94A6}"/>
              </a:ext>
            </a:extLst>
          </p:cNvPr>
          <p:cNvSpPr txBox="1"/>
          <p:nvPr/>
        </p:nvSpPr>
        <p:spPr>
          <a:xfrm>
            <a:off x="9013519" y="634069"/>
            <a:ext cx="282946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</p:spTree>
    <p:extLst>
      <p:ext uri="{BB962C8B-B14F-4D97-AF65-F5344CB8AC3E}">
        <p14:creationId xmlns:p14="http://schemas.microsoft.com/office/powerpoint/2010/main" val="1499360833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26FD1FC-45FD-4CB7-A4BE-4C6B08CB33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19100"/>
            <a:ext cx="12192000" cy="60198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A2C3390A-5C0D-4A91-B765-3F57BA7BBE1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27299" y="2201154"/>
            <a:ext cx="3011093" cy="19569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9013519" y="634069"/>
            <a:ext cx="282946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ED011CC-7A0E-4B81-9903-AD277135C811}"/>
              </a:ext>
            </a:extLst>
          </p:cNvPr>
          <p:cNvSpPr txBox="1"/>
          <p:nvPr/>
        </p:nvSpPr>
        <p:spPr>
          <a:xfrm>
            <a:off x="4052540" y="2362137"/>
            <a:ext cx="15888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7 /1+, </a:t>
            </a:r>
            <a:r>
              <a:rPr lang="en-US" sz="16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188.527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949829F-DF94-4567-865A-531EDC30EB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79960" y="2351621"/>
            <a:ext cx="4011654" cy="18064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82A4865-67EA-4474-813D-E0447A88CE6B}"/>
              </a:ext>
            </a:extLst>
          </p:cNvPr>
          <p:cNvSpPr txBox="1"/>
          <p:nvPr/>
        </p:nvSpPr>
        <p:spPr>
          <a:xfrm>
            <a:off x="9299693" y="2376251"/>
            <a:ext cx="15888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8 /1+, </a:t>
            </a:r>
            <a:r>
              <a:rPr lang="en-US" sz="16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945.822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4D5A278-CF77-4307-90D1-0B8E7B74395E}"/>
              </a:ext>
            </a:extLst>
          </p:cNvPr>
          <p:cNvSpPr/>
          <p:nvPr/>
        </p:nvSpPr>
        <p:spPr>
          <a:xfrm>
            <a:off x="7256832" y="5029200"/>
            <a:ext cx="213399" cy="40319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7E52DB1A-6CAB-43CF-A522-2A92481B3EE3}"/>
              </a:ext>
            </a:extLst>
          </p:cNvPr>
          <p:cNvCxnSpPr>
            <a:cxnSpLocks/>
            <a:stCxn id="13" idx="0"/>
            <a:endCxn id="27" idx="2"/>
          </p:cNvCxnSpPr>
          <p:nvPr/>
        </p:nvCxnSpPr>
        <p:spPr>
          <a:xfrm flipH="1" flipV="1">
            <a:off x="5532846" y="4158074"/>
            <a:ext cx="1830686" cy="87112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E89BAA70-3906-4388-8BBE-2728D3926785}"/>
              </a:ext>
            </a:extLst>
          </p:cNvPr>
          <p:cNvSpPr/>
          <p:nvPr/>
        </p:nvSpPr>
        <p:spPr>
          <a:xfrm>
            <a:off x="11555274" y="5027696"/>
            <a:ext cx="213399" cy="40319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0A27A7E2-B297-4BA8-95E3-C116FB73E4A5}"/>
              </a:ext>
            </a:extLst>
          </p:cNvPr>
          <p:cNvCxnSpPr>
            <a:cxnSpLocks/>
            <a:stCxn id="17" idx="0"/>
            <a:endCxn id="10" idx="3"/>
          </p:cNvCxnSpPr>
          <p:nvPr/>
        </p:nvCxnSpPr>
        <p:spPr>
          <a:xfrm flipH="1" flipV="1">
            <a:off x="11491614" y="3254848"/>
            <a:ext cx="170360" cy="177284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65056785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26FD1FC-45FD-4CB7-A4BE-4C6B08CB33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19100"/>
            <a:ext cx="12192000" cy="60198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71C2E80-DA70-4A19-AA9D-22FD7770A4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57088" y="2663388"/>
            <a:ext cx="4219546" cy="2393002"/>
          </a:xfrm>
          <a:prstGeom prst="rect">
            <a:avLst/>
          </a:prstGeom>
          <a:ln>
            <a:solidFill>
              <a:schemeClr val="dk1"/>
            </a:solidFill>
          </a:ln>
        </p:spPr>
      </p:pic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8C5BDAD-ED08-4356-A112-8211244080DC}"/>
              </a:ext>
            </a:extLst>
          </p:cNvPr>
          <p:cNvCxnSpPr>
            <a:cxnSpLocks/>
            <a:endCxn id="4" idx="3"/>
          </p:cNvCxnSpPr>
          <p:nvPr/>
        </p:nvCxnSpPr>
        <p:spPr>
          <a:xfrm flipH="1">
            <a:off x="6276634" y="2315183"/>
            <a:ext cx="270081" cy="15447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CABE0C96-5678-41F7-8E0B-0A4FF07F94A6}"/>
              </a:ext>
            </a:extLst>
          </p:cNvPr>
          <p:cNvSpPr txBox="1"/>
          <p:nvPr/>
        </p:nvSpPr>
        <p:spPr>
          <a:xfrm>
            <a:off x="9013519" y="634069"/>
            <a:ext cx="282946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7BF7989-601F-415F-B057-1B121A75F118}"/>
              </a:ext>
            </a:extLst>
          </p:cNvPr>
          <p:cNvSpPr txBox="1"/>
          <p:nvPr/>
        </p:nvSpPr>
        <p:spPr>
          <a:xfrm rot="16200000">
            <a:off x="6883756" y="4044235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5 /1+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386EDCC-42AF-45D3-AB3D-297DA808B652}"/>
              </a:ext>
            </a:extLst>
          </p:cNvPr>
          <p:cNvSpPr txBox="1"/>
          <p:nvPr/>
        </p:nvSpPr>
        <p:spPr>
          <a:xfrm>
            <a:off x="3322720" y="2748982"/>
            <a:ext cx="1688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z21 /2+, </a:t>
            </a:r>
            <a:r>
              <a:rPr lang="en-US" sz="16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1063.588</a:t>
            </a:r>
          </a:p>
        </p:txBody>
      </p:sp>
    </p:spTree>
    <p:extLst>
      <p:ext uri="{BB962C8B-B14F-4D97-AF65-F5344CB8AC3E}">
        <p14:creationId xmlns:p14="http://schemas.microsoft.com/office/powerpoint/2010/main" val="3761460501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>
            <a:normAutofit/>
          </a:bodyPr>
          <a:lstStyle/>
          <a:p>
            <a:r>
              <a:rPr lang="en-US" sz="2400" dirty="0"/>
              <a:t>Spectrum 4</a:t>
            </a:r>
          </a:p>
          <a:p>
            <a:endParaRPr lang="en-US" sz="2400" dirty="0"/>
          </a:p>
          <a:p>
            <a:r>
              <a:rPr lang="en-US" sz="2400" dirty="0"/>
              <a:t>RAW=1-2, HCD Scan=16216, EThcD Scan=16217</a:t>
            </a:r>
          </a:p>
          <a:p>
            <a:endParaRPr lang="en-US" sz="2400" dirty="0"/>
          </a:p>
          <a:p>
            <a:r>
              <a:rPr lang="en-US" sz="2400" dirty="0"/>
              <a:t>Peptide: LHVPLMPAQPAPPKPQPTTR, protein: F12</a:t>
            </a:r>
          </a:p>
          <a:p>
            <a:endParaRPr lang="en-US" sz="2400" dirty="0"/>
          </a:p>
          <a:p>
            <a:r>
              <a:rPr lang="en-US" sz="2400" dirty="0"/>
              <a:t>SSGL: T18-H(1)N(1)@97%, T19-H(1)N(1)A(1)@97%</a:t>
            </a:r>
          </a:p>
          <a:p>
            <a:pPr lvl="1"/>
            <a:endParaRPr lang="en-US" sz="2400" dirty="0"/>
          </a:p>
          <a:p>
            <a:r>
              <a:rPr lang="en-US" sz="2400" dirty="0"/>
              <a:t>SSGL on protein: </a:t>
            </a:r>
          </a:p>
          <a:p>
            <a:pPr lvl="1"/>
            <a:r>
              <a:rPr lang="pt-BR" sz="2000" dirty="0"/>
              <a:t>T328-H(1)N(1)A(1), T329-H(1)N(1)A(1)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591251512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9934" y="0"/>
            <a:ext cx="10972795" cy="685799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7277412" y="196448"/>
            <a:ext cx="3350331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3772504964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73C04AF-6C09-4B15-9E63-0D2F8DEFBD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820"/>
            <a:ext cx="12192000" cy="61150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8118574" y="274142"/>
            <a:ext cx="282946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4E61F3BC-F58D-4277-B5FD-A1391E9B5C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7460955"/>
              </p:ext>
            </p:extLst>
          </p:nvPr>
        </p:nvGraphicFramePr>
        <p:xfrm>
          <a:off x="51896" y="6136326"/>
          <a:ext cx="12091464" cy="6193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47832">
                  <a:extLst>
                    <a:ext uri="{9D8B030D-6E8A-4147-A177-3AD203B41FA5}">
                      <a16:colId xmlns:a16="http://schemas.microsoft.com/office/drawing/2014/main" val="801040992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1882249816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310552662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1251615595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380690946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4009266098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4221684270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4073171588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793593081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1474633472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2787851977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2506841214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1819185998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2570835964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1879726457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3866820368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2586412933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1626042357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2143534186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3125335858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3813391588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2550004163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3154094016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831575256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2688666214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2755249227"/>
                    </a:ext>
                  </a:extLst>
                </a:gridCol>
                <a:gridCol w="447832">
                  <a:extLst>
                    <a:ext uri="{9D8B030D-6E8A-4147-A177-3AD203B41FA5}">
                      <a16:colId xmlns:a16="http://schemas.microsoft.com/office/drawing/2014/main" val="3776160138"/>
                    </a:ext>
                  </a:extLst>
                </a:gridCol>
              </a:tblGrid>
              <a:tr h="116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Fr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2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4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5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7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8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10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13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17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8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15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16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17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18 2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19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8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5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3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2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5+H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3+H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2+H 1+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+H 1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9+H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6+H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10+H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z7+H 2+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extLst>
                  <a:ext uri="{0D108BD9-81ED-4DB2-BD59-A6C34878D82A}">
                    <a16:rowId xmlns:a16="http://schemas.microsoft.com/office/drawing/2014/main" val="403625422"/>
                  </a:ext>
                </a:extLst>
              </a:tr>
              <a:tr h="116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/z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68.1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64.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77.3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05.4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76.5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101.6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366.7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817.0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38.7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96.4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60.4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09.0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287.657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666.2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611.7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457.1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343.1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307.5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899.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674.6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917.394</a:t>
                      </a:r>
                      <a:endParaRPr lang="en-US" sz="10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60.1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680.7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514.2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195.5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062.9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868" marR="4868" marT="4868" marB="0" anchor="b"/>
                </a:tc>
                <a:extLst>
                  <a:ext uri="{0D108BD9-81ED-4DB2-BD59-A6C34878D82A}">
                    <a16:rowId xmlns:a16="http://schemas.microsoft.com/office/drawing/2014/main" val="14711325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334709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29463D9-6E23-482A-BA1A-DD2436BAE9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196" y="163286"/>
            <a:ext cx="7919150" cy="326571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14929D9-04F1-4498-BCE2-03A8AA9AD6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194" y="3425031"/>
            <a:ext cx="7919150" cy="267713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D6A9F96-8957-43F8-96EA-C00EF2A33F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194" y="6101124"/>
            <a:ext cx="7919150" cy="67795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2FF0E47-72DA-4CDF-B7BA-85DF699EE7AA}"/>
              </a:ext>
            </a:extLst>
          </p:cNvPr>
          <p:cNvSpPr txBox="1"/>
          <p:nvPr/>
        </p:nvSpPr>
        <p:spPr>
          <a:xfrm>
            <a:off x="3597150" y="6286731"/>
            <a:ext cx="1075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N-labeled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E7B4B15E-8CC7-4AE8-8B65-1EEE2E186817}"/>
              </a:ext>
            </a:extLst>
          </p:cNvPr>
          <p:cNvGraphicFramePr>
            <a:graphicFrameLocks noGrp="1"/>
          </p:cNvGraphicFramePr>
          <p:nvPr/>
        </p:nvGraphicFramePr>
        <p:xfrm>
          <a:off x="8338362" y="369125"/>
          <a:ext cx="3325230" cy="6409952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1286054">
                  <a:extLst>
                    <a:ext uri="{9D8B030D-6E8A-4147-A177-3AD203B41FA5}">
                      <a16:colId xmlns:a16="http://schemas.microsoft.com/office/drawing/2014/main" val="2495189960"/>
                    </a:ext>
                  </a:extLst>
                </a:gridCol>
                <a:gridCol w="1019588">
                  <a:extLst>
                    <a:ext uri="{9D8B030D-6E8A-4147-A177-3AD203B41FA5}">
                      <a16:colId xmlns:a16="http://schemas.microsoft.com/office/drawing/2014/main" val="4140547952"/>
                    </a:ext>
                  </a:extLst>
                </a:gridCol>
                <a:gridCol w="1019588">
                  <a:extLst>
                    <a:ext uri="{9D8B030D-6E8A-4147-A177-3AD203B41FA5}">
                      <a16:colId xmlns:a16="http://schemas.microsoft.com/office/drawing/2014/main" val="939405415"/>
                    </a:ext>
                  </a:extLst>
                </a:gridCol>
              </a:tblGrid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Fragment typ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38" marR="7138" marT="713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/z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38" marR="7138" marT="713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15N-m/z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38" marR="7138" marT="7138" marB="0" anchor="b"/>
                </a:tc>
                <a:extLst>
                  <a:ext uri="{0D108BD9-81ED-4DB2-BD59-A6C34878D82A}">
                    <a16:rowId xmlns:a16="http://schemas.microsoft.com/office/drawing/2014/main" val="2722843352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0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9.54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5.505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455189368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0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0.27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8.25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166113076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1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4.38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3.351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16785371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1)N(2) 3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3.25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9.236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86941001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2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5.40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4.38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59006003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2)N(2) 3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7.27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3.26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8424775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3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6.43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5.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465447125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3)N(2) 3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1.29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7.275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91977416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4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7.46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6.442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596969123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5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8.49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7.45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15753245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6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9.514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58.492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72324011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8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11.56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0.541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60536416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pt-B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H(9)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92.5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1.59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968169382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1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2.62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9.57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940147933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1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1.81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0.292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667011733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2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25.70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43.65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91178608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2) 2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3.35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2.331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290980655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-N(2) 3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9.24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5.22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6896394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2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8.13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1.124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948916745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3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9.169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3.15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810018625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5-N(1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3.33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1.29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30132152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6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6.32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5.309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065538938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1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5.118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.10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32532010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2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6.16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1.15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276819420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3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3.18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9.1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16308878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4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4.233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1.213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487894179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5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0.316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9.289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453134284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7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1.377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3.347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590170897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7-N(1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4.461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37.431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022132608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8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2.42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5.38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178272571"/>
                  </a:ext>
                </a:extLst>
              </a:tr>
              <a:tr h="2003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8-N(1) 1+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5.505</a:t>
                      </a: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9.458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328400112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95D4054-D7AF-45BC-BC86-7C9D6354F581}"/>
              </a:ext>
            </a:extLst>
          </p:cNvPr>
          <p:cNvSpPr txBox="1"/>
          <p:nvPr/>
        </p:nvSpPr>
        <p:spPr>
          <a:xfrm>
            <a:off x="8486174" y="0"/>
            <a:ext cx="3050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tched same fragment types</a:t>
            </a:r>
          </a:p>
        </p:txBody>
      </p:sp>
    </p:spTree>
    <p:extLst>
      <p:ext uri="{BB962C8B-B14F-4D97-AF65-F5344CB8AC3E}">
        <p14:creationId xmlns:p14="http://schemas.microsoft.com/office/powerpoint/2010/main" val="2435730623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73C04AF-6C09-4B15-9E63-0D2F8DEFBD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71475"/>
            <a:ext cx="12192000" cy="61150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8118574" y="643797"/>
            <a:ext cx="282946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512C35A-E5A0-4706-AF54-A4BCC855CC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10337" y="2024094"/>
            <a:ext cx="1538707" cy="2809811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59C7F3A-CFAC-4B88-8173-98A60CBBC1C2}"/>
              </a:ext>
            </a:extLst>
          </p:cNvPr>
          <p:cNvSpPr/>
          <p:nvPr/>
        </p:nvSpPr>
        <p:spPr>
          <a:xfrm>
            <a:off x="5914410" y="5129506"/>
            <a:ext cx="162134" cy="2897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3BF3597C-44F2-4206-B771-DEEC30D3E08A}"/>
              </a:ext>
            </a:extLst>
          </p:cNvPr>
          <p:cNvCxnSpPr>
            <a:cxnSpLocks/>
            <a:stCxn id="6" idx="0"/>
            <a:endCxn id="3" idx="3"/>
          </p:cNvCxnSpPr>
          <p:nvPr/>
        </p:nvCxnSpPr>
        <p:spPr>
          <a:xfrm flipH="1" flipV="1">
            <a:off x="5749044" y="3429000"/>
            <a:ext cx="246433" cy="17005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2FBB5B0-1563-4322-B6E7-D5C29442F31F}"/>
              </a:ext>
            </a:extLst>
          </p:cNvPr>
          <p:cNvSpPr txBox="1"/>
          <p:nvPr/>
        </p:nvSpPr>
        <p:spPr>
          <a:xfrm rot="16200000">
            <a:off x="4868739" y="2284459"/>
            <a:ext cx="9332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z2+H /1+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9E273D0-6030-4368-BEE8-829A79860C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3317" y="1899551"/>
            <a:ext cx="3375953" cy="2423370"/>
          </a:xfrm>
          <a:prstGeom prst="rect">
            <a:avLst/>
          </a:prstGeom>
        </p:spPr>
      </p:pic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1D06392-636C-4A10-9E85-12A44B106FC2}"/>
              </a:ext>
            </a:extLst>
          </p:cNvPr>
          <p:cNvCxnSpPr>
            <a:cxnSpLocks/>
            <a:stCxn id="11" idx="0"/>
          </p:cNvCxnSpPr>
          <p:nvPr/>
        </p:nvCxnSpPr>
        <p:spPr>
          <a:xfrm flipH="1">
            <a:off x="3764604" y="2453736"/>
            <a:ext cx="1401493" cy="10676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Rectangle 23">
            <a:extLst>
              <a:ext uri="{FF2B5EF4-FFF2-40B4-BE49-F238E27FC236}">
                <a16:creationId xmlns:a16="http://schemas.microsoft.com/office/drawing/2014/main" id="{4AF63D82-0D05-4A4E-BD93-E81FDEF5DE03}"/>
              </a:ext>
            </a:extLst>
          </p:cNvPr>
          <p:cNvSpPr/>
          <p:nvPr/>
        </p:nvSpPr>
        <p:spPr>
          <a:xfrm>
            <a:off x="8086147" y="5130422"/>
            <a:ext cx="162134" cy="2897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007BEFE6-4FFF-4BEE-AF88-8F9E41E13676}"/>
              </a:ext>
            </a:extLst>
          </p:cNvPr>
          <p:cNvCxnSpPr>
            <a:cxnSpLocks/>
            <a:stCxn id="24" idx="0"/>
            <a:endCxn id="30" idx="1"/>
          </p:cNvCxnSpPr>
          <p:nvPr/>
        </p:nvCxnSpPr>
        <p:spPr>
          <a:xfrm flipV="1">
            <a:off x="8167214" y="4363121"/>
            <a:ext cx="420325" cy="76730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0" name="Picture 29">
            <a:extLst>
              <a:ext uri="{FF2B5EF4-FFF2-40B4-BE49-F238E27FC236}">
                <a16:creationId xmlns:a16="http://schemas.microsoft.com/office/drawing/2014/main" id="{9DF755BC-AD2A-475C-8A2F-4FBA367014A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87539" y="3558680"/>
            <a:ext cx="2581550" cy="1608881"/>
          </a:xfrm>
          <a:prstGeom prst="rect">
            <a:avLst/>
          </a:prstGeom>
          <a:ln>
            <a:solidFill>
              <a:schemeClr val="dk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982040FF-F9B7-4D1A-8569-09CD49F73D28}"/>
              </a:ext>
            </a:extLst>
          </p:cNvPr>
          <p:cNvSpPr txBox="1"/>
          <p:nvPr/>
        </p:nvSpPr>
        <p:spPr>
          <a:xfrm rot="16200000">
            <a:off x="8629851" y="3747923"/>
            <a:ext cx="8114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18 /2+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50082A55-4AF2-4611-AD91-9B05309EC1F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483605" y="1774450"/>
            <a:ext cx="1841018" cy="2126342"/>
          </a:xfrm>
          <a:prstGeom prst="rect">
            <a:avLst/>
          </a:prstGeom>
        </p:spPr>
      </p:pic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0D953437-3186-4455-8CF0-B4E095441256}"/>
              </a:ext>
            </a:extLst>
          </p:cNvPr>
          <p:cNvCxnSpPr>
            <a:cxnSpLocks/>
            <a:stCxn id="31" idx="2"/>
          </p:cNvCxnSpPr>
          <p:nvPr/>
        </p:nvCxnSpPr>
        <p:spPr>
          <a:xfrm flipV="1">
            <a:off x="9204849" y="2110902"/>
            <a:ext cx="600632" cy="180629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9491034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D1F521-CDD5-4E38-B2F0-6931DBA31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65125"/>
            <a:ext cx="10515600" cy="4351338"/>
          </a:xfrm>
        </p:spPr>
        <p:txBody>
          <a:bodyPr>
            <a:normAutofit/>
          </a:bodyPr>
          <a:lstStyle/>
          <a:p>
            <a:r>
              <a:rPr lang="en-US" sz="2400" dirty="0"/>
              <a:t>Spectrum 3</a:t>
            </a:r>
          </a:p>
          <a:p>
            <a:endParaRPr lang="en-US" sz="2400" dirty="0"/>
          </a:p>
          <a:p>
            <a:r>
              <a:rPr lang="en-US" sz="2400" dirty="0"/>
              <a:t>RAW=1-1, HCD Scan=28818, EThcD Scan=28819</a:t>
            </a:r>
          </a:p>
          <a:p>
            <a:endParaRPr lang="en-US" sz="2400" dirty="0"/>
          </a:p>
          <a:p>
            <a:r>
              <a:rPr lang="en-US" sz="2400" dirty="0"/>
              <a:t>Peptide: IEETTMTTQTPAPIQAPSAILPLPGQSVER, protein: ITIH4</a:t>
            </a:r>
          </a:p>
          <a:p>
            <a:endParaRPr lang="en-US" sz="2400" dirty="0"/>
          </a:p>
          <a:p>
            <a:r>
              <a:rPr lang="en-US" sz="2400" dirty="0"/>
              <a:t>SSGL: S18-H(3)N(2)A(1)F(1)@82%</a:t>
            </a:r>
          </a:p>
          <a:p>
            <a:pPr lvl="1"/>
            <a:endParaRPr lang="en-US" sz="2400" dirty="0"/>
          </a:p>
          <a:p>
            <a:r>
              <a:rPr lang="en-US" sz="2400" dirty="0"/>
              <a:t>SSGL on protein</a:t>
            </a:r>
          </a:p>
          <a:p>
            <a:pPr lvl="1"/>
            <a:r>
              <a:rPr lang="pt-BR" sz="2000" dirty="0"/>
              <a:t>S733-H(3)N(2)A(1)F(1)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037114175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BE8011-5C97-4286-A3C9-C5155EA6A2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9933" y="0"/>
            <a:ext cx="10972797" cy="685799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0B86B7A-D151-4EFC-9A19-9613BC10AE9A}"/>
              </a:ext>
            </a:extLst>
          </p:cNvPr>
          <p:cNvSpPr txBox="1"/>
          <p:nvPr/>
        </p:nvSpPr>
        <p:spPr>
          <a:xfrm>
            <a:off x="8745025" y="215903"/>
            <a:ext cx="3350331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Merged spectrum of </a:t>
            </a:r>
            <a:r>
              <a:rPr lang="en-US" dirty="0" err="1"/>
              <a:t>HCD+EThcD</a:t>
            </a:r>
            <a:r>
              <a:rPr lang="en-US" dirty="0"/>
              <a:t>, </a:t>
            </a:r>
          </a:p>
          <a:p>
            <a:r>
              <a:rPr lang="en-US" dirty="0"/>
              <a:t>b/y/c/z and Y ions are annotated</a:t>
            </a:r>
          </a:p>
          <a:p>
            <a:r>
              <a:rPr lang="en-US" dirty="0"/>
              <a:t>before SSGL</a:t>
            </a:r>
          </a:p>
        </p:txBody>
      </p:sp>
    </p:spTree>
    <p:extLst>
      <p:ext uri="{BB962C8B-B14F-4D97-AF65-F5344CB8AC3E}">
        <p14:creationId xmlns:p14="http://schemas.microsoft.com/office/powerpoint/2010/main" val="2316275679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29CF3212-A73E-4EC4-AB3A-5425BC6298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26490"/>
            <a:ext cx="12192000" cy="6099173"/>
          </a:xfrm>
          <a:prstGeom prst="rect">
            <a:avLst/>
          </a:prstGeom>
        </p:spPr>
      </p:pic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52D5419F-ABB8-4CFC-B14A-9C36A8A8C6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6911059"/>
              </p:ext>
            </p:extLst>
          </p:nvPr>
        </p:nvGraphicFramePr>
        <p:xfrm>
          <a:off x="337226" y="6293757"/>
          <a:ext cx="9144000" cy="365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53251701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10896395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11974548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53510312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10011926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2701412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2460514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80793436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90165478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70542765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9698593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28760483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23293137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593737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50225457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Fragmen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c2 1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c3 1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c13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12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10 1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z8 1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z5 1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z4 1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z2 1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z1 1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20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z22+H 2+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19+H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z17+H 2+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13281174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/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60.1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89.2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>
                          <a:solidFill>
                            <a:srgbClr val="C00000"/>
                          </a:solidFill>
                          <a:effectLst/>
                        </a:rPr>
                        <a:t>1418.699</a:t>
                      </a:r>
                      <a:endParaRPr lang="en-US" sz="1100" b="1" i="0" u="none" strike="noStrike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263.726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079.606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69.4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02.3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74.2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88.1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59.1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677.803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792.8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629.785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1" u="none" strike="noStrike" dirty="0">
                          <a:solidFill>
                            <a:srgbClr val="C00000"/>
                          </a:solidFill>
                          <a:effectLst/>
                        </a:rPr>
                        <a:t>1545.741</a:t>
                      </a:r>
                      <a:endParaRPr lang="en-US" sz="1100" b="1" i="0" u="none" strike="noStrike" dirty="0">
                        <a:solidFill>
                          <a:srgbClr val="C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0762815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87976434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29CF3212-A73E-4EC4-AB3A-5425BC6298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79413"/>
            <a:ext cx="12192000" cy="6099173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8964879" y="128231"/>
            <a:ext cx="282946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4B08CF8-6B4B-42E1-AD0D-2C452BBF8B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89245" y="1778619"/>
            <a:ext cx="1175634" cy="7410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5482E86-E8D2-4591-8EBA-01E49D2337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05866" y="2899317"/>
            <a:ext cx="1464914" cy="66256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28DBC6F-7AF6-46B6-AE3A-04611B57A1B9}"/>
              </a:ext>
            </a:extLst>
          </p:cNvPr>
          <p:cNvSpPr txBox="1"/>
          <p:nvPr/>
        </p:nvSpPr>
        <p:spPr>
          <a:xfrm>
            <a:off x="7884667" y="1778619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z12 /1+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8691F8F-B6BB-4121-A244-36DD97C23940}"/>
              </a:ext>
            </a:extLst>
          </p:cNvPr>
          <p:cNvCxnSpPr>
            <a:cxnSpLocks/>
            <a:endCxn id="3" idx="2"/>
          </p:cNvCxnSpPr>
          <p:nvPr/>
        </p:nvCxnSpPr>
        <p:spPr>
          <a:xfrm flipV="1">
            <a:off x="7789245" y="2519624"/>
            <a:ext cx="587817" cy="32765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A5EF4287-439D-4CEF-9F4A-D303784D49B9}"/>
              </a:ext>
            </a:extLst>
          </p:cNvPr>
          <p:cNvCxnSpPr>
            <a:cxnSpLocks/>
            <a:endCxn id="5" idx="0"/>
          </p:cNvCxnSpPr>
          <p:nvPr/>
        </p:nvCxnSpPr>
        <p:spPr>
          <a:xfrm flipH="1">
            <a:off x="6338323" y="2423532"/>
            <a:ext cx="272455" cy="4757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87C2B768-4DA4-445E-993C-4A954AF1E4E1}"/>
              </a:ext>
            </a:extLst>
          </p:cNvPr>
          <p:cNvSpPr txBox="1"/>
          <p:nvPr/>
        </p:nvSpPr>
        <p:spPr>
          <a:xfrm>
            <a:off x="5658787" y="2899317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z10 /1+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F5E513AF-8F9E-43D4-93A3-C474B89CB9E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22161" y="1833594"/>
            <a:ext cx="2473755" cy="164752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95988CC-8CDE-4B22-B0E5-85A6F72435C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533882" y="3495698"/>
            <a:ext cx="1812298" cy="15619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16630AAC-A31E-48CC-B4CC-F1DDB409ADEE}"/>
              </a:ext>
            </a:extLst>
          </p:cNvPr>
          <p:cNvSpPr/>
          <p:nvPr/>
        </p:nvSpPr>
        <p:spPr>
          <a:xfrm>
            <a:off x="9263063" y="5129506"/>
            <a:ext cx="162134" cy="2897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81A86D3A-D24C-474D-AB0C-C9A9F940A895}"/>
              </a:ext>
            </a:extLst>
          </p:cNvPr>
          <p:cNvCxnSpPr>
            <a:cxnSpLocks/>
            <a:stCxn id="23" idx="0"/>
            <a:endCxn id="22" idx="1"/>
          </p:cNvCxnSpPr>
          <p:nvPr/>
        </p:nvCxnSpPr>
        <p:spPr>
          <a:xfrm flipV="1">
            <a:off x="9344130" y="4276689"/>
            <a:ext cx="189752" cy="8528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20915163-F1A6-4251-A34B-6BD61CEB54C7}"/>
              </a:ext>
            </a:extLst>
          </p:cNvPr>
          <p:cNvCxnSpPr>
            <a:cxnSpLocks/>
            <a:stCxn id="22" idx="0"/>
          </p:cNvCxnSpPr>
          <p:nvPr/>
        </p:nvCxnSpPr>
        <p:spPr>
          <a:xfrm flipV="1">
            <a:off x="10440031" y="3037818"/>
            <a:ext cx="814709" cy="4578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21629071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29CF3212-A73E-4EC4-AB3A-5425BC6298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79413"/>
            <a:ext cx="12192000" cy="6099173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C7FCF2C-9166-4126-B8A0-9CD0302A3D28}"/>
              </a:ext>
            </a:extLst>
          </p:cNvPr>
          <p:cNvSpPr txBox="1"/>
          <p:nvPr/>
        </p:nvSpPr>
        <p:spPr>
          <a:xfrm>
            <a:off x="8964879" y="128231"/>
            <a:ext cx="282946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EThcD spectrum of SSGL, b/y ions are not annotate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A788E35-FBA1-4E40-8048-A6A69D142C4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31985" y="2600811"/>
            <a:ext cx="4602879" cy="19356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94340874-5EE3-475C-A1EA-F06C07A8A2B5}"/>
              </a:ext>
            </a:extLst>
          </p:cNvPr>
          <p:cNvSpPr/>
          <p:nvPr/>
        </p:nvSpPr>
        <p:spPr>
          <a:xfrm>
            <a:off x="10498688" y="5122126"/>
            <a:ext cx="182880" cy="28971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899D4AD-4F1A-4EF8-AE5A-509F727702B1}"/>
              </a:ext>
            </a:extLst>
          </p:cNvPr>
          <p:cNvCxnSpPr>
            <a:cxnSpLocks/>
            <a:stCxn id="5" idx="1"/>
            <a:endCxn id="4" idx="2"/>
          </p:cNvCxnSpPr>
          <p:nvPr/>
        </p:nvCxnSpPr>
        <p:spPr>
          <a:xfrm flipH="1" flipV="1">
            <a:off x="7233425" y="4536459"/>
            <a:ext cx="3265263" cy="73052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E8636BE7-0770-40D8-997C-D3B6EB2B8313}"/>
              </a:ext>
            </a:extLst>
          </p:cNvPr>
          <p:cNvSpPr txBox="1"/>
          <p:nvPr/>
        </p:nvSpPr>
        <p:spPr>
          <a:xfrm rot="16200000">
            <a:off x="5222493" y="3161499"/>
            <a:ext cx="13644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Y-N(1)F(1) /2+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C30646A-9C4F-4A9D-B6D2-5321E012BB73}"/>
              </a:ext>
            </a:extLst>
          </p:cNvPr>
          <p:cNvSpPr txBox="1"/>
          <p:nvPr/>
        </p:nvSpPr>
        <p:spPr>
          <a:xfrm>
            <a:off x="6062857" y="2653057"/>
            <a:ext cx="158428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aybe the fucose rearrangement also happens in the EThcD spectra of O-</a:t>
            </a:r>
            <a:r>
              <a:rPr lang="en-US" sz="1400" dirty="0" err="1"/>
              <a:t>GalNAc</a:t>
            </a:r>
            <a:r>
              <a:rPr lang="en-US" sz="1400" dirty="0"/>
              <a:t> glycopeptid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0183A8-D557-45E7-A7EA-2C0848BA5DD7}"/>
              </a:ext>
            </a:extLst>
          </p:cNvPr>
          <p:cNvSpPr txBox="1"/>
          <p:nvPr/>
        </p:nvSpPr>
        <p:spPr>
          <a:xfrm>
            <a:off x="8159026" y="2662410"/>
            <a:ext cx="1398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Y-H(1)N(1) /2+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77CDD91-7A3D-4CDC-AADA-95ED8CAD3A0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66395" y="2347131"/>
            <a:ext cx="1463167" cy="1577477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96A005F-1E0E-437F-983A-1A3CE30B87D5}"/>
              </a:ext>
            </a:extLst>
          </p:cNvPr>
          <p:cNvCxnSpPr>
            <a:cxnSpLocks/>
          </p:cNvCxnSpPr>
          <p:nvPr/>
        </p:nvCxnSpPr>
        <p:spPr>
          <a:xfrm flipH="1" flipV="1">
            <a:off x="4259767" y="3135869"/>
            <a:ext cx="1803090" cy="10399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81924065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188991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834724-C576-48D2-A156-A2EC5CBE41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err="1"/>
              <a:t>gLabel</a:t>
            </a:r>
            <a:r>
              <a:rPr lang="en-US" dirty="0"/>
              <a:t> enables annotation of 15N-labeled MS2</a:t>
            </a:r>
            <a:br>
              <a:rPr lang="en-US" dirty="0"/>
            </a:br>
            <a:r>
              <a:rPr lang="en-US" dirty="0"/>
              <a:t> -- </a:t>
            </a:r>
            <a:r>
              <a:rPr lang="en-US" sz="3200" dirty="0" err="1"/>
              <a:t>gLabel</a:t>
            </a:r>
            <a:r>
              <a:rPr lang="en-US" sz="3200" dirty="0"/>
              <a:t> is in pGlyco3 software packag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F8FDBCE-F554-4DB9-8714-ED56448E1E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1521"/>
            <a:ext cx="12192000" cy="487240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AA5D739-3704-4F15-A473-47A7D6D59553}"/>
              </a:ext>
            </a:extLst>
          </p:cNvPr>
          <p:cNvSpPr/>
          <p:nvPr/>
        </p:nvSpPr>
        <p:spPr>
          <a:xfrm>
            <a:off x="3996965" y="2026756"/>
            <a:ext cx="1263191" cy="273378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7227A4F-DDB6-4BC9-953B-1DDD46C5540A}"/>
              </a:ext>
            </a:extLst>
          </p:cNvPr>
          <p:cNvSpPr/>
          <p:nvPr/>
        </p:nvSpPr>
        <p:spPr>
          <a:xfrm>
            <a:off x="6811653" y="2051894"/>
            <a:ext cx="2256934" cy="273378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C3111ED-BB57-441A-9BD4-80DD5D5545D3}"/>
              </a:ext>
            </a:extLst>
          </p:cNvPr>
          <p:cNvSpPr/>
          <p:nvPr/>
        </p:nvSpPr>
        <p:spPr>
          <a:xfrm>
            <a:off x="6898065" y="3879909"/>
            <a:ext cx="1802875" cy="273378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8092E5C2-6F68-460D-A01E-E5B3FE64A14B}"/>
              </a:ext>
            </a:extLst>
          </p:cNvPr>
          <p:cNvCxnSpPr>
            <a:cxnSpLocks/>
            <a:stCxn id="5" idx="3"/>
            <a:endCxn id="6" idx="1"/>
          </p:cNvCxnSpPr>
          <p:nvPr/>
        </p:nvCxnSpPr>
        <p:spPr>
          <a:xfrm>
            <a:off x="5260156" y="2163445"/>
            <a:ext cx="1551497" cy="25138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1A7B425D-7D32-4D7F-AEEB-3A1341AA4F00}"/>
              </a:ext>
            </a:extLst>
          </p:cNvPr>
          <p:cNvCxnSpPr>
            <a:cxnSpLocks/>
            <a:stCxn id="6" idx="2"/>
            <a:endCxn id="7" idx="0"/>
          </p:cNvCxnSpPr>
          <p:nvPr/>
        </p:nvCxnSpPr>
        <p:spPr>
          <a:xfrm flipH="1">
            <a:off x="7799503" y="2325272"/>
            <a:ext cx="140617" cy="1554637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803752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7CC61F9-3641-43D2-BF24-3F2B876553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176" y="891320"/>
            <a:ext cx="5578323" cy="507536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4068872E-9665-4C36-A3A7-D055FB19CD9D}"/>
              </a:ext>
            </a:extLst>
          </p:cNvPr>
          <p:cNvSpPr/>
          <p:nvPr/>
        </p:nvSpPr>
        <p:spPr>
          <a:xfrm>
            <a:off x="1866508" y="3535045"/>
            <a:ext cx="2950590" cy="320518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258594D-692F-4C64-9A6C-F76ABD26BA0B}"/>
              </a:ext>
            </a:extLst>
          </p:cNvPr>
          <p:cNvSpPr/>
          <p:nvPr/>
        </p:nvSpPr>
        <p:spPr>
          <a:xfrm>
            <a:off x="1866508" y="4196494"/>
            <a:ext cx="2950590" cy="320518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91F698C-1DDF-4784-8D02-FA519F20AE47}"/>
              </a:ext>
            </a:extLst>
          </p:cNvPr>
          <p:cNvSpPr/>
          <p:nvPr/>
        </p:nvSpPr>
        <p:spPr>
          <a:xfrm>
            <a:off x="1875935" y="4669403"/>
            <a:ext cx="2950590" cy="320518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31F3BCA-3AA0-465E-9CA8-FF966B4E4282}"/>
              </a:ext>
            </a:extLst>
          </p:cNvPr>
          <p:cNvSpPr txBox="1"/>
          <p:nvPr/>
        </p:nvSpPr>
        <p:spPr>
          <a:xfrm>
            <a:off x="7076387" y="1329175"/>
            <a:ext cx="36198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pectrum TITLE in the MGF file processed by </a:t>
            </a:r>
            <a:r>
              <a:rPr lang="en-US" dirty="0" err="1"/>
              <a:t>pParse</a:t>
            </a:r>
            <a:endParaRPr lang="en-US" dirty="0"/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E78379C5-02FE-4A00-A931-24A4D3B86D65}"/>
              </a:ext>
            </a:extLst>
          </p:cNvPr>
          <p:cNvCxnSpPr>
            <a:stCxn id="8" idx="3"/>
            <a:endCxn id="11" idx="1"/>
          </p:cNvCxnSpPr>
          <p:nvPr/>
        </p:nvCxnSpPr>
        <p:spPr>
          <a:xfrm flipV="1">
            <a:off x="4817098" y="1652341"/>
            <a:ext cx="2259289" cy="2042963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9326BF3A-4568-4A3E-893C-B8C1C54FB263}"/>
              </a:ext>
            </a:extLst>
          </p:cNvPr>
          <p:cNvSpPr txBox="1"/>
          <p:nvPr/>
        </p:nvSpPr>
        <p:spPr>
          <a:xfrm>
            <a:off x="7048904" y="2703629"/>
            <a:ext cx="464975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elf-defined glycan:</a:t>
            </a:r>
          </a:p>
          <a:p>
            <a:r>
              <a:rPr lang="en-US" dirty="0"/>
              <a:t>H N|10 2|4 2;5 2;6 2;7 2;8 2;9 2</a:t>
            </a:r>
          </a:p>
          <a:p>
            <a:r>
              <a:rPr lang="en-US" dirty="0" err="1"/>
              <a:t>glyco</a:t>
            </a:r>
            <a:r>
              <a:rPr lang="en-US" dirty="0"/>
              <a:t> </a:t>
            </a:r>
            <a:r>
              <a:rPr lang="en-US" dirty="0" err="1"/>
              <a:t>names|glycan</a:t>
            </a:r>
            <a:r>
              <a:rPr lang="en-US" dirty="0"/>
              <a:t> </a:t>
            </a:r>
            <a:r>
              <a:rPr lang="en-US" dirty="0" err="1"/>
              <a:t>composition|glycan</a:t>
            </a:r>
            <a:r>
              <a:rPr lang="en-US" dirty="0"/>
              <a:t> Y ions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D8A596CA-CAB7-4971-A062-F9EB20CB36AF}"/>
              </a:ext>
            </a:extLst>
          </p:cNvPr>
          <p:cNvCxnSpPr>
            <a:cxnSpLocks/>
            <a:stCxn id="9" idx="3"/>
            <a:endCxn id="14" idx="1"/>
          </p:cNvCxnSpPr>
          <p:nvPr/>
        </p:nvCxnSpPr>
        <p:spPr>
          <a:xfrm flipV="1">
            <a:off x="4817098" y="3165294"/>
            <a:ext cx="2231806" cy="1191459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4B37F074-E929-4A3F-BBFB-36CC8D054D92}"/>
              </a:ext>
            </a:extLst>
          </p:cNvPr>
          <p:cNvSpPr txBox="1"/>
          <p:nvPr/>
        </p:nvSpPr>
        <p:spPr>
          <a:xfrm>
            <a:off x="7076387" y="4192226"/>
            <a:ext cx="484852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elf-defined peptide:</a:t>
            </a:r>
          </a:p>
          <a:p>
            <a:r>
              <a:rPr lang="en-US" dirty="0"/>
              <a:t>VQASJWTGTR|5|</a:t>
            </a:r>
          </a:p>
          <a:p>
            <a:r>
              <a:rPr lang="en-US" dirty="0"/>
              <a:t>peptide </a:t>
            </a:r>
            <a:r>
              <a:rPr lang="en-US" dirty="0" err="1"/>
              <a:t>sequence|glyco</a:t>
            </a:r>
            <a:r>
              <a:rPr lang="en-US" dirty="0"/>
              <a:t> </a:t>
            </a:r>
            <a:r>
              <a:rPr lang="en-US" dirty="0" err="1"/>
              <a:t>site|other</a:t>
            </a:r>
            <a:r>
              <a:rPr lang="en-US" dirty="0"/>
              <a:t> modifications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233666DA-636D-418A-BC4B-820B7D00999E}"/>
              </a:ext>
            </a:extLst>
          </p:cNvPr>
          <p:cNvCxnSpPr>
            <a:cxnSpLocks/>
            <a:stCxn id="10" idx="3"/>
            <a:endCxn id="21" idx="1"/>
          </p:cNvCxnSpPr>
          <p:nvPr/>
        </p:nvCxnSpPr>
        <p:spPr>
          <a:xfrm flipV="1">
            <a:off x="4826525" y="4653891"/>
            <a:ext cx="2249862" cy="175771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F9223594-0110-437F-957B-11C49DBE0BD2}"/>
              </a:ext>
            </a:extLst>
          </p:cNvPr>
          <p:cNvSpPr/>
          <p:nvPr/>
        </p:nvSpPr>
        <p:spPr>
          <a:xfrm>
            <a:off x="4915878" y="4672541"/>
            <a:ext cx="919314" cy="317380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32C3C85-42E7-42A2-BB0C-0FB717B011C6}"/>
              </a:ext>
            </a:extLst>
          </p:cNvPr>
          <p:cNvSpPr txBox="1"/>
          <p:nvPr/>
        </p:nvSpPr>
        <p:spPr>
          <a:xfrm>
            <a:off x="7076387" y="5272677"/>
            <a:ext cx="4649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lick “show this”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28581CCC-F62C-4359-B418-9EC10C1F319C}"/>
              </a:ext>
            </a:extLst>
          </p:cNvPr>
          <p:cNvCxnSpPr>
            <a:cxnSpLocks/>
            <a:stCxn id="26" idx="2"/>
            <a:endCxn id="27" idx="1"/>
          </p:cNvCxnSpPr>
          <p:nvPr/>
        </p:nvCxnSpPr>
        <p:spPr>
          <a:xfrm>
            <a:off x="5375535" y="4989921"/>
            <a:ext cx="1700852" cy="467422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069110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A6E1B949-189E-4F22-A97D-527586F4CF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5760"/>
            <a:ext cx="12192000" cy="6086480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AB9F94FC-537E-4F5D-98F7-D4586E672E54}"/>
              </a:ext>
            </a:extLst>
          </p:cNvPr>
          <p:cNvSpPr/>
          <p:nvPr/>
        </p:nvSpPr>
        <p:spPr>
          <a:xfrm>
            <a:off x="3167406" y="556181"/>
            <a:ext cx="1649691" cy="238811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BF05095-C382-464C-9CCD-4F4AB322EEAC}"/>
              </a:ext>
            </a:extLst>
          </p:cNvPr>
          <p:cNvSpPr txBox="1"/>
          <p:nvPr/>
        </p:nvSpPr>
        <p:spPr>
          <a:xfrm>
            <a:off x="5260158" y="527900"/>
            <a:ext cx="618398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e PEPMASS of cwq_mix2-1_726.17948.17948.3.0.dta is the m/z of VQASJ(H9N2aH1)WTGTR-3+, so it is 0.31 Th smaller than 15N-labeled VQASJ(H10N2)WTGTR-3+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82DEDCB8-8BC9-4409-998F-A8484FA51796}"/>
              </a:ext>
            </a:extLst>
          </p:cNvPr>
          <p:cNvCxnSpPr>
            <a:stCxn id="16" idx="3"/>
            <a:endCxn id="17" idx="1"/>
          </p:cNvCxnSpPr>
          <p:nvPr/>
        </p:nvCxnSpPr>
        <p:spPr>
          <a:xfrm>
            <a:off x="4817097" y="675587"/>
            <a:ext cx="443061" cy="313978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101716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9382538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49</TotalTime>
  <Words>2922</Words>
  <Application>Microsoft Office PowerPoint</Application>
  <PresentationFormat>Widescreen</PresentationFormat>
  <Paragraphs>719</Paragraphs>
  <Slides>56</Slides>
  <Notes>2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6</vt:i4>
      </vt:variant>
    </vt:vector>
  </HeadingPairs>
  <TitlesOfParts>
    <vt:vector size="60" baseType="lpstr">
      <vt:lpstr>Arial</vt:lpstr>
      <vt:lpstr>Calibri</vt:lpstr>
      <vt:lpstr>Calibri Light</vt:lpstr>
      <vt:lpstr>Office Theme</vt:lpstr>
      <vt:lpstr>1. The MS2 in Fig. 4b is a chimera spectrum</vt:lpstr>
      <vt:lpstr>PowerPoint Presentation</vt:lpstr>
      <vt:lpstr>PowerPoint Presentation</vt:lpstr>
      <vt:lpstr>PowerPoint Presentation</vt:lpstr>
      <vt:lpstr>PowerPoint Presentation</vt:lpstr>
      <vt:lpstr>gLabel enables annotation of 15N-labeled MS2  -- gLabel is in pGlyco3 software package</vt:lpstr>
      <vt:lpstr>PowerPoint Presentation</vt:lpstr>
      <vt:lpstr>PowerPoint Presentation</vt:lpstr>
      <vt:lpstr>PowerPoint Presentation</vt:lpstr>
      <vt:lpstr>2. Annotated spectra of double-site N-glycopeptides of IgM (Fig. 2d)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3. Spectrum annotation examples of O-glycopeptides in human serum data (Fig. 3e)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eng Wen-Feng</dc:creator>
  <cp:lastModifiedBy>Zeng Wen-Feng</cp:lastModifiedBy>
  <cp:revision>1020</cp:revision>
  <dcterms:created xsi:type="dcterms:W3CDTF">2021-07-04T20:30:39Z</dcterms:created>
  <dcterms:modified xsi:type="dcterms:W3CDTF">2021-07-16T10:58:49Z</dcterms:modified>
</cp:coreProperties>
</file>